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3" r:id="rId2"/>
    <p:sldId id="264" r:id="rId3"/>
  </p:sldIdLst>
  <p:sldSz cx="6227763" cy="6858000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6A87CB9-998E-4A09-8BA1-66EF0B8AA220}" v="67" dt="2025-05-19T15:40:35.79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中間スタイル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D27102A9-8310-4765-A935-A1911B00CA55}" styleName="淡色スタイル 1 - アクセント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47" autoAdjust="0"/>
    <p:restoredTop sz="89018" autoAdjust="0"/>
  </p:normalViewPr>
  <p:slideViewPr>
    <p:cSldViewPr snapToGrid="0">
      <p:cViewPr>
        <p:scale>
          <a:sx n="126" d="100"/>
          <a:sy n="126" d="100"/>
        </p:scale>
        <p:origin x="736" y="2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勇治 箱崎" userId="9db2de78f3965622" providerId="LiveId" clId="{79395050-4831-4A35-B497-197B4FC0979E}"/>
    <pc:docChg chg="delSld">
      <pc:chgData name="勇治 箱崎" userId="9db2de78f3965622" providerId="LiveId" clId="{79395050-4831-4A35-B497-197B4FC0979E}" dt="2025-03-16T03:04:18.247" v="0" actId="47"/>
      <pc:docMkLst>
        <pc:docMk/>
      </pc:docMkLst>
      <pc:sldChg chg="del">
        <pc:chgData name="勇治 箱崎" userId="9db2de78f3965622" providerId="LiveId" clId="{79395050-4831-4A35-B497-197B4FC0979E}" dt="2025-03-16T03:04:18.247" v="0" actId="47"/>
        <pc:sldMkLst>
          <pc:docMk/>
          <pc:sldMk cId="692380640" sldId="259"/>
        </pc:sldMkLst>
      </pc:sldChg>
      <pc:sldChg chg="del">
        <pc:chgData name="勇治 箱崎" userId="9db2de78f3965622" providerId="LiveId" clId="{79395050-4831-4A35-B497-197B4FC0979E}" dt="2025-03-16T03:04:18.247" v="0" actId="47"/>
        <pc:sldMkLst>
          <pc:docMk/>
          <pc:sldMk cId="594557811" sldId="261"/>
        </pc:sldMkLst>
      </pc:sldChg>
    </pc:docChg>
  </pc:docChgLst>
  <pc:docChgLst>
    <pc:chgData name="勇治 箱崎" userId="9db2de78f3965622" providerId="LiveId" clId="{B5669114-2DEB-4562-B8CD-5528970886F2}"/>
    <pc:docChg chg="undo custSel addSld delSld modSld sldOrd">
      <pc:chgData name="勇治 箱崎" userId="9db2de78f3965622" providerId="LiveId" clId="{B5669114-2DEB-4562-B8CD-5528970886F2}" dt="2025-01-15T10:56:49.614" v="1732" actId="20577"/>
      <pc:docMkLst>
        <pc:docMk/>
      </pc:docMkLst>
      <pc:sldChg chg="addSp delSp modSp add mod">
        <pc:chgData name="勇治 箱崎" userId="9db2de78f3965622" providerId="LiveId" clId="{B5669114-2DEB-4562-B8CD-5528970886F2}" dt="2025-01-15T10:56:32.188" v="1727" actId="1076"/>
        <pc:sldMkLst>
          <pc:docMk/>
          <pc:sldMk cId="692380640" sldId="259"/>
        </pc:sldMkLst>
      </pc:sldChg>
      <pc:sldChg chg="modSp mod ord">
        <pc:chgData name="勇治 箱崎" userId="9db2de78f3965622" providerId="LiveId" clId="{B5669114-2DEB-4562-B8CD-5528970886F2}" dt="2025-01-15T10:56:14.395" v="1720" actId="20577"/>
        <pc:sldMkLst>
          <pc:docMk/>
          <pc:sldMk cId="594557811" sldId="261"/>
        </pc:sldMkLst>
      </pc:sldChg>
      <pc:sldChg chg="new del">
        <pc:chgData name="勇治 箱崎" userId="9db2de78f3965622" providerId="LiveId" clId="{B5669114-2DEB-4562-B8CD-5528970886F2}" dt="2025-01-04T01:40:29.831" v="1029" actId="47"/>
        <pc:sldMkLst>
          <pc:docMk/>
          <pc:sldMk cId="1189182068" sldId="262"/>
        </pc:sldMkLst>
      </pc:sldChg>
      <pc:sldChg chg="del">
        <pc:chgData name="勇治 箱崎" userId="9db2de78f3965622" providerId="LiveId" clId="{B5669114-2DEB-4562-B8CD-5528970886F2}" dt="2025-01-04T01:09:49.154" v="606" actId="47"/>
        <pc:sldMkLst>
          <pc:docMk/>
          <pc:sldMk cId="3562092320" sldId="262"/>
        </pc:sldMkLst>
      </pc:sldChg>
      <pc:sldChg chg="addSp delSp modSp add mod">
        <pc:chgData name="勇治 箱崎" userId="9db2de78f3965622" providerId="LiveId" clId="{B5669114-2DEB-4562-B8CD-5528970886F2}" dt="2025-01-15T10:56:49.614" v="1732" actId="20577"/>
        <pc:sldMkLst>
          <pc:docMk/>
          <pc:sldMk cId="2705313201" sldId="263"/>
        </pc:sldMkLst>
      </pc:sldChg>
      <pc:sldChg chg="del">
        <pc:chgData name="勇治 箱崎" userId="9db2de78f3965622" providerId="LiveId" clId="{B5669114-2DEB-4562-B8CD-5528970886F2}" dt="2025-01-04T00:46:05.284" v="1" actId="47"/>
        <pc:sldMkLst>
          <pc:docMk/>
          <pc:sldMk cId="3973636590" sldId="288"/>
        </pc:sldMkLst>
      </pc:sldChg>
      <pc:sldChg chg="del">
        <pc:chgData name="勇治 箱崎" userId="9db2de78f3965622" providerId="LiveId" clId="{B5669114-2DEB-4562-B8CD-5528970886F2}" dt="2025-01-04T01:09:49.154" v="606" actId="47"/>
        <pc:sldMkLst>
          <pc:docMk/>
          <pc:sldMk cId="294657801" sldId="290"/>
        </pc:sldMkLst>
      </pc:sldChg>
      <pc:sldChg chg="del">
        <pc:chgData name="勇治 箱崎" userId="9db2de78f3965622" providerId="LiveId" clId="{B5669114-2DEB-4562-B8CD-5528970886F2}" dt="2025-01-04T01:09:49.154" v="606" actId="47"/>
        <pc:sldMkLst>
          <pc:docMk/>
          <pc:sldMk cId="1816511275" sldId="291"/>
        </pc:sldMkLst>
      </pc:sldChg>
      <pc:sldChg chg="modSp add del mod">
        <pc:chgData name="勇治 箱崎" userId="9db2de78f3965622" providerId="LiveId" clId="{B5669114-2DEB-4562-B8CD-5528970886F2}" dt="2025-01-04T01:09:49.154" v="606" actId="47"/>
        <pc:sldMkLst>
          <pc:docMk/>
          <pc:sldMk cId="2661319145" sldId="292"/>
        </pc:sldMkLst>
      </pc:sldChg>
    </pc:docChg>
  </pc:docChgLst>
  <pc:docChgLst>
    <pc:chgData name="勇治 箱崎" userId="9db2de78f3965622" providerId="LiveId" clId="{F3BAA24D-41A6-4CB4-9001-F8C01AF06D58}"/>
    <pc:docChg chg="undo custSel modSld">
      <pc:chgData name="勇治 箱崎" userId="9db2de78f3965622" providerId="LiveId" clId="{F3BAA24D-41A6-4CB4-9001-F8C01AF06D58}" dt="2024-03-07T00:36:57.915" v="18" actId="1076"/>
      <pc:docMkLst>
        <pc:docMk/>
      </pc:docMkLst>
      <pc:sldChg chg="modSp mod">
        <pc:chgData name="勇治 箱崎" userId="9db2de78f3965622" providerId="LiveId" clId="{F3BAA24D-41A6-4CB4-9001-F8C01AF06D58}" dt="2024-03-07T00:36:57.915" v="18" actId="1076"/>
        <pc:sldMkLst>
          <pc:docMk/>
          <pc:sldMk cId="594557811" sldId="261"/>
        </pc:sldMkLst>
      </pc:sldChg>
      <pc:sldChg chg="modSp mod">
        <pc:chgData name="勇治 箱崎" userId="9db2de78f3965622" providerId="LiveId" clId="{F3BAA24D-41A6-4CB4-9001-F8C01AF06D58}" dt="2024-03-07T00:35:56.886" v="1" actId="14100"/>
        <pc:sldMkLst>
          <pc:docMk/>
          <pc:sldMk cId="3562092320" sldId="262"/>
        </pc:sldMkLst>
      </pc:sldChg>
    </pc:docChg>
  </pc:docChgLst>
  <pc:docChgLst>
    <pc:chgData name="勇治 箱崎" userId="9db2de78f3965622" providerId="LiveId" clId="{5B2AEB1F-E50E-4C48-88E2-849225976E96}"/>
    <pc:docChg chg="undo custSel delSld modSld sldOrd">
      <pc:chgData name="勇治 箱崎" userId="9db2de78f3965622" providerId="LiveId" clId="{5B2AEB1F-E50E-4C48-88E2-849225976E96}" dt="2024-02-10T07:56:36.345" v="3759" actId="1038"/>
      <pc:docMkLst>
        <pc:docMk/>
      </pc:docMkLst>
      <pc:sldChg chg="addSp delSp modSp mod">
        <pc:chgData name="勇治 箱崎" userId="9db2de78f3965622" providerId="LiveId" clId="{5B2AEB1F-E50E-4C48-88E2-849225976E96}" dt="2024-02-10T05:39:20.186" v="708" actId="20577"/>
        <pc:sldMkLst>
          <pc:docMk/>
          <pc:sldMk cId="3562092320" sldId="262"/>
        </pc:sldMkLst>
      </pc:sldChg>
      <pc:sldChg chg="del">
        <pc:chgData name="勇治 箱崎" userId="9db2de78f3965622" providerId="LiveId" clId="{5B2AEB1F-E50E-4C48-88E2-849225976E96}" dt="2024-02-10T07:47:08.741" v="3699" actId="47"/>
        <pc:sldMkLst>
          <pc:docMk/>
          <pc:sldMk cId="1408471767" sldId="280"/>
        </pc:sldMkLst>
      </pc:sldChg>
      <pc:sldChg chg="modSp mod">
        <pc:chgData name="勇治 箱崎" userId="9db2de78f3965622" providerId="LiveId" clId="{5B2AEB1F-E50E-4C48-88E2-849225976E96}" dt="2024-02-10T07:49:19.782" v="3708" actId="1038"/>
        <pc:sldMkLst>
          <pc:docMk/>
          <pc:sldMk cId="3973636590" sldId="288"/>
        </pc:sldMkLst>
      </pc:sldChg>
      <pc:sldChg chg="del">
        <pc:chgData name="勇治 箱崎" userId="9db2de78f3965622" providerId="LiveId" clId="{5B2AEB1F-E50E-4C48-88E2-849225976E96}" dt="2024-02-10T06:57:03.842" v="1690" actId="47"/>
        <pc:sldMkLst>
          <pc:docMk/>
          <pc:sldMk cId="215150484" sldId="289"/>
        </pc:sldMkLst>
      </pc:sldChg>
      <pc:sldChg chg="addSp delSp modSp mod ord">
        <pc:chgData name="勇治 箱崎" userId="9db2de78f3965622" providerId="LiveId" clId="{5B2AEB1F-E50E-4C48-88E2-849225976E96}" dt="2024-02-10T07:56:36.345" v="3759" actId="1038"/>
        <pc:sldMkLst>
          <pc:docMk/>
          <pc:sldMk cId="294657801" sldId="290"/>
        </pc:sldMkLst>
      </pc:sldChg>
      <pc:sldChg chg="addSp delSp modSp mod">
        <pc:chgData name="勇治 箱崎" userId="9db2de78f3965622" providerId="LiveId" clId="{5B2AEB1F-E50E-4C48-88E2-849225976E96}" dt="2024-02-10T06:56:01.917" v="1687" actId="478"/>
        <pc:sldMkLst>
          <pc:docMk/>
          <pc:sldMk cId="1816511275" sldId="291"/>
        </pc:sldMkLst>
      </pc:sldChg>
    </pc:docChg>
  </pc:docChgLst>
  <pc:docChgLst>
    <pc:chgData name="勇治 箱崎" userId="9db2de78f3965622" providerId="LiveId" clId="{345E5166-3E50-4D21-BD38-6F2762E6C7D0}"/>
    <pc:docChg chg="undo custSel modSld sldOrd">
      <pc:chgData name="勇治 箱崎" userId="9db2de78f3965622" providerId="LiveId" clId="{345E5166-3E50-4D21-BD38-6F2762E6C7D0}" dt="2025-01-13T08:57:38.080" v="1047"/>
      <pc:docMkLst>
        <pc:docMk/>
      </pc:docMkLst>
      <pc:sldChg chg="addSp delSp modSp mod">
        <pc:chgData name="勇治 箱崎" userId="9db2de78f3965622" providerId="LiveId" clId="{345E5166-3E50-4D21-BD38-6F2762E6C7D0}" dt="2025-01-10T06:26:24.968" v="1043" actId="1037"/>
        <pc:sldMkLst>
          <pc:docMk/>
          <pc:sldMk cId="692380640" sldId="259"/>
        </pc:sldMkLst>
      </pc:sldChg>
      <pc:sldChg chg="addSp modSp mod">
        <pc:chgData name="勇治 箱崎" userId="9db2de78f3965622" providerId="LiveId" clId="{345E5166-3E50-4D21-BD38-6F2762E6C7D0}" dt="2024-12-28T01:49:12.558" v="292" actId="20577"/>
        <pc:sldMkLst>
          <pc:docMk/>
          <pc:sldMk cId="594557811" sldId="261"/>
        </pc:sldMkLst>
      </pc:sldChg>
      <pc:sldChg chg="addSp delSp modSp mod ord">
        <pc:chgData name="勇治 箱崎" userId="9db2de78f3965622" providerId="LiveId" clId="{345E5166-3E50-4D21-BD38-6F2762E6C7D0}" dt="2025-01-13T08:57:38.080" v="1047"/>
        <pc:sldMkLst>
          <pc:docMk/>
          <pc:sldMk cId="2705313201" sldId="263"/>
        </pc:sldMkLst>
      </pc:sldChg>
    </pc:docChg>
  </pc:docChgLst>
  <pc:docChgLst>
    <pc:chgData name="勇治 箱崎" userId="9db2de78f3965622" providerId="LiveId" clId="{56A87CB9-998E-4A09-8BA1-66EF0B8AA220}"/>
    <pc:docChg chg="undo custSel addSld modSld">
      <pc:chgData name="勇治 箱崎" userId="9db2de78f3965622" providerId="LiveId" clId="{56A87CB9-998E-4A09-8BA1-66EF0B8AA220}" dt="2025-05-19T15:42:30.546" v="2103" actId="1035"/>
      <pc:docMkLst>
        <pc:docMk/>
      </pc:docMkLst>
      <pc:sldChg chg="modSp mod">
        <pc:chgData name="勇治 箱崎" userId="9db2de78f3965622" providerId="LiveId" clId="{56A87CB9-998E-4A09-8BA1-66EF0B8AA220}" dt="2025-05-19T12:10:51.405" v="2005" actId="20577"/>
        <pc:sldMkLst>
          <pc:docMk/>
          <pc:sldMk cId="2705313201" sldId="263"/>
        </pc:sldMkLst>
        <pc:spChg chg="mod">
          <ac:chgData name="勇治 箱崎" userId="9db2de78f3965622" providerId="LiveId" clId="{56A87CB9-998E-4A09-8BA1-66EF0B8AA220}" dt="2025-05-19T12:10:51.405" v="2005" actId="20577"/>
          <ac:spMkLst>
            <pc:docMk/>
            <pc:sldMk cId="2705313201" sldId="263"/>
            <ac:spMk id="11" creationId="{0E325283-1FEB-C872-5E1C-4F54076163DB}"/>
          </ac:spMkLst>
        </pc:spChg>
        <pc:spChg chg="ord">
          <ac:chgData name="勇治 箱崎" userId="9db2de78f3965622" providerId="LiveId" clId="{56A87CB9-998E-4A09-8BA1-66EF0B8AA220}" dt="2025-05-17T22:39:31.814" v="1787" actId="167"/>
          <ac:spMkLst>
            <pc:docMk/>
            <pc:sldMk cId="2705313201" sldId="263"/>
            <ac:spMk id="29" creationId="{F72BFF46-D68B-AE0E-2228-BDB9CD5EAA5C}"/>
          </ac:spMkLst>
        </pc:spChg>
      </pc:sldChg>
      <pc:sldChg chg="addSp delSp modSp new mod">
        <pc:chgData name="勇治 箱崎" userId="9db2de78f3965622" providerId="LiveId" clId="{56A87CB9-998E-4A09-8BA1-66EF0B8AA220}" dt="2025-05-19T15:42:30.546" v="2103" actId="1035"/>
        <pc:sldMkLst>
          <pc:docMk/>
          <pc:sldMk cId="2518644381" sldId="264"/>
        </pc:sldMkLst>
        <pc:spChg chg="add mod">
          <ac:chgData name="勇治 箱崎" userId="9db2de78f3965622" providerId="LiveId" clId="{56A87CB9-998E-4A09-8BA1-66EF0B8AA220}" dt="2025-05-19T09:48:11.128" v="1972" actId="20577"/>
          <ac:spMkLst>
            <pc:docMk/>
            <pc:sldMk cId="2518644381" sldId="264"/>
            <ac:spMk id="2" creationId="{DE0CD572-8571-19D9-D754-49A0068F2F2B}"/>
          </ac:spMkLst>
        </pc:spChg>
        <pc:spChg chg="add mod">
          <ac:chgData name="勇治 箱崎" userId="9db2de78f3965622" providerId="LiveId" clId="{56A87CB9-998E-4A09-8BA1-66EF0B8AA220}" dt="2025-05-17T21:04:22.187" v="102" actId="14100"/>
          <ac:spMkLst>
            <pc:docMk/>
            <pc:sldMk cId="2518644381" sldId="264"/>
            <ac:spMk id="3" creationId="{19564159-ED57-7AD7-0439-79207F1769D3}"/>
          </ac:spMkLst>
        </pc:spChg>
        <pc:spChg chg="add mod">
          <ac:chgData name="勇治 箱崎" userId="9db2de78f3965622" providerId="LiveId" clId="{56A87CB9-998E-4A09-8BA1-66EF0B8AA220}" dt="2025-05-19T09:47:27.402" v="1968" actId="20577"/>
          <ac:spMkLst>
            <pc:docMk/>
            <pc:sldMk cId="2518644381" sldId="264"/>
            <ac:spMk id="5" creationId="{616225DE-9F43-8575-1FB4-134FCCB0AD0D}"/>
          </ac:spMkLst>
        </pc:spChg>
        <pc:spChg chg="add mod">
          <ac:chgData name="勇治 箱崎" userId="9db2de78f3965622" providerId="LiveId" clId="{56A87CB9-998E-4A09-8BA1-66EF0B8AA220}" dt="2025-05-19T12:10:37.651" v="2003" actId="20577"/>
          <ac:spMkLst>
            <pc:docMk/>
            <pc:sldMk cId="2518644381" sldId="264"/>
            <ac:spMk id="6" creationId="{2786464F-5576-2082-981C-E4BA3D894B71}"/>
          </ac:spMkLst>
        </pc:spChg>
        <pc:spChg chg="add mod">
          <ac:chgData name="勇治 箱崎" userId="9db2de78f3965622" providerId="LiveId" clId="{56A87CB9-998E-4A09-8BA1-66EF0B8AA220}" dt="2025-05-17T22:22:17.808" v="553" actId="1038"/>
          <ac:spMkLst>
            <pc:docMk/>
            <pc:sldMk cId="2518644381" sldId="264"/>
            <ac:spMk id="9" creationId="{3BEC2C17-A437-E2E4-9EB0-65F5AE397DA5}"/>
          </ac:spMkLst>
        </pc:spChg>
        <pc:spChg chg="add mod">
          <ac:chgData name="勇治 箱崎" userId="9db2de78f3965622" providerId="LiveId" clId="{56A87CB9-998E-4A09-8BA1-66EF0B8AA220}" dt="2025-05-17T21:13:20.774" v="391" actId="122"/>
          <ac:spMkLst>
            <pc:docMk/>
            <pc:sldMk cId="2518644381" sldId="264"/>
            <ac:spMk id="10" creationId="{7F789040-0DB6-1DD6-FAE3-E71F0E149F15}"/>
          </ac:spMkLst>
        </pc:spChg>
        <pc:spChg chg="add mod">
          <ac:chgData name="勇治 箱崎" userId="9db2de78f3965622" providerId="LiveId" clId="{56A87CB9-998E-4A09-8BA1-66EF0B8AA220}" dt="2025-05-17T22:22:33.411" v="557" actId="1076"/>
          <ac:spMkLst>
            <pc:docMk/>
            <pc:sldMk cId="2518644381" sldId="264"/>
            <ac:spMk id="11" creationId="{373110D2-FF63-FAB6-BC22-18C320082927}"/>
          </ac:spMkLst>
        </pc:spChg>
        <pc:spChg chg="add mod">
          <ac:chgData name="勇治 箱崎" userId="9db2de78f3965622" providerId="LiveId" clId="{56A87CB9-998E-4A09-8BA1-66EF0B8AA220}" dt="2025-05-17T21:14:02.747" v="442" actId="20577"/>
          <ac:spMkLst>
            <pc:docMk/>
            <pc:sldMk cId="2518644381" sldId="264"/>
            <ac:spMk id="12" creationId="{5DAB7AF2-C16E-F527-E250-3FB22B452884}"/>
          </ac:spMkLst>
        </pc:spChg>
        <pc:spChg chg="add mod">
          <ac:chgData name="勇治 箱崎" userId="9db2de78f3965622" providerId="LiveId" clId="{56A87CB9-998E-4A09-8BA1-66EF0B8AA220}" dt="2025-05-17T21:14:29.282" v="485" actId="20577"/>
          <ac:spMkLst>
            <pc:docMk/>
            <pc:sldMk cId="2518644381" sldId="264"/>
            <ac:spMk id="13" creationId="{55B96E5F-AE06-119D-C9FB-21C814483076}"/>
          </ac:spMkLst>
        </pc:spChg>
        <pc:spChg chg="add mod">
          <ac:chgData name="勇治 箱崎" userId="9db2de78f3965622" providerId="LiveId" clId="{56A87CB9-998E-4A09-8BA1-66EF0B8AA220}" dt="2025-05-17T21:15:21.276" v="511" actId="1076"/>
          <ac:spMkLst>
            <pc:docMk/>
            <pc:sldMk cId="2518644381" sldId="264"/>
            <ac:spMk id="14" creationId="{74C585A3-2CBC-0D5A-4D4B-A26A52F6A03B}"/>
          </ac:spMkLst>
        </pc:spChg>
        <pc:spChg chg="add mod">
          <ac:chgData name="勇治 箱崎" userId="9db2de78f3965622" providerId="LiveId" clId="{56A87CB9-998E-4A09-8BA1-66EF0B8AA220}" dt="2025-05-17T21:15:25.185" v="512" actId="1076"/>
          <ac:spMkLst>
            <pc:docMk/>
            <pc:sldMk cId="2518644381" sldId="264"/>
            <ac:spMk id="15" creationId="{1F065E87-9213-5E0F-6FE3-2566AD0E2C52}"/>
          </ac:spMkLst>
        </pc:spChg>
        <pc:spChg chg="add mod">
          <ac:chgData name="勇治 箱崎" userId="9db2de78f3965622" providerId="LiveId" clId="{56A87CB9-998E-4A09-8BA1-66EF0B8AA220}" dt="2025-05-17T21:15:32.390" v="514" actId="1076"/>
          <ac:spMkLst>
            <pc:docMk/>
            <pc:sldMk cId="2518644381" sldId="264"/>
            <ac:spMk id="16" creationId="{08F5B854-278F-1A29-F386-39377E6E58B3}"/>
          </ac:spMkLst>
        </pc:spChg>
        <pc:spChg chg="add mod">
          <ac:chgData name="勇治 箱崎" userId="9db2de78f3965622" providerId="LiveId" clId="{56A87CB9-998E-4A09-8BA1-66EF0B8AA220}" dt="2025-05-17T21:15:42.204" v="518" actId="20577"/>
          <ac:spMkLst>
            <pc:docMk/>
            <pc:sldMk cId="2518644381" sldId="264"/>
            <ac:spMk id="17" creationId="{90405378-75AB-DABD-F267-1C88A448E830}"/>
          </ac:spMkLst>
        </pc:spChg>
        <pc:spChg chg="add mod">
          <ac:chgData name="勇治 箱崎" userId="9db2de78f3965622" providerId="LiveId" clId="{56A87CB9-998E-4A09-8BA1-66EF0B8AA220}" dt="2025-05-17T21:15:50.431" v="522" actId="20577"/>
          <ac:spMkLst>
            <pc:docMk/>
            <pc:sldMk cId="2518644381" sldId="264"/>
            <ac:spMk id="18" creationId="{F92132BC-B2FC-A0E9-CADC-D740420262E4}"/>
          </ac:spMkLst>
        </pc:spChg>
        <pc:spChg chg="add mod">
          <ac:chgData name="勇治 箱崎" userId="9db2de78f3965622" providerId="LiveId" clId="{56A87CB9-998E-4A09-8BA1-66EF0B8AA220}" dt="2025-05-17T21:16:00.676" v="529" actId="20577"/>
          <ac:spMkLst>
            <pc:docMk/>
            <pc:sldMk cId="2518644381" sldId="264"/>
            <ac:spMk id="19" creationId="{851B257C-72E1-F97A-BC33-F4E5108494EE}"/>
          </ac:spMkLst>
        </pc:spChg>
        <pc:spChg chg="add mod">
          <ac:chgData name="勇治 箱崎" userId="9db2de78f3965622" providerId="LiveId" clId="{56A87CB9-998E-4A09-8BA1-66EF0B8AA220}" dt="2025-05-17T21:16:07.990" v="533" actId="20577"/>
          <ac:spMkLst>
            <pc:docMk/>
            <pc:sldMk cId="2518644381" sldId="264"/>
            <ac:spMk id="20" creationId="{F47156B7-48C7-35E3-A9EC-C023FA8F63F6}"/>
          </ac:spMkLst>
        </pc:spChg>
        <pc:spChg chg="add mod">
          <ac:chgData name="勇治 箱崎" userId="9db2de78f3965622" providerId="LiveId" clId="{56A87CB9-998E-4A09-8BA1-66EF0B8AA220}" dt="2025-05-17T21:16:18.327" v="542" actId="20577"/>
          <ac:spMkLst>
            <pc:docMk/>
            <pc:sldMk cId="2518644381" sldId="264"/>
            <ac:spMk id="21" creationId="{EC035596-5561-AFE6-B68F-0B3660B5869B}"/>
          </ac:spMkLst>
        </pc:spChg>
        <pc:spChg chg="add mod">
          <ac:chgData name="勇治 箱崎" userId="9db2de78f3965622" providerId="LiveId" clId="{56A87CB9-998E-4A09-8BA1-66EF0B8AA220}" dt="2025-05-17T21:16:29.393" v="547" actId="20577"/>
          <ac:spMkLst>
            <pc:docMk/>
            <pc:sldMk cId="2518644381" sldId="264"/>
            <ac:spMk id="22" creationId="{C17FE1CA-2F20-EA25-BC2A-ADAE6E996FD5}"/>
          </ac:spMkLst>
        </pc:spChg>
        <pc:spChg chg="add mod">
          <ac:chgData name="勇治 箱崎" userId="9db2de78f3965622" providerId="LiveId" clId="{56A87CB9-998E-4A09-8BA1-66EF0B8AA220}" dt="2025-05-17T22:22:40.066" v="563" actId="20577"/>
          <ac:spMkLst>
            <pc:docMk/>
            <pc:sldMk cId="2518644381" sldId="264"/>
            <ac:spMk id="23" creationId="{FAEAD577-AD90-53C3-41E5-0C68B1C8EB47}"/>
          </ac:spMkLst>
        </pc:spChg>
        <pc:spChg chg="add mod">
          <ac:chgData name="勇治 箱崎" userId="9db2de78f3965622" providerId="LiveId" clId="{56A87CB9-998E-4A09-8BA1-66EF0B8AA220}" dt="2025-05-17T22:23:06.409" v="621" actId="20577"/>
          <ac:spMkLst>
            <pc:docMk/>
            <pc:sldMk cId="2518644381" sldId="264"/>
            <ac:spMk id="24" creationId="{4D62E1AB-89E0-4F99-595A-3F324CB8FF8A}"/>
          </ac:spMkLst>
        </pc:spChg>
        <pc:spChg chg="add mod">
          <ac:chgData name="勇治 箱崎" userId="9db2de78f3965622" providerId="LiveId" clId="{56A87CB9-998E-4A09-8BA1-66EF0B8AA220}" dt="2025-05-17T22:23:19.937" v="633" actId="20577"/>
          <ac:spMkLst>
            <pc:docMk/>
            <pc:sldMk cId="2518644381" sldId="264"/>
            <ac:spMk id="25" creationId="{FFAE9ADA-E532-AB84-1BD0-C2262F83DF3C}"/>
          </ac:spMkLst>
        </pc:spChg>
        <pc:spChg chg="add mod">
          <ac:chgData name="勇治 箱崎" userId="9db2de78f3965622" providerId="LiveId" clId="{56A87CB9-998E-4A09-8BA1-66EF0B8AA220}" dt="2025-05-17T22:23:33.709" v="639" actId="20577"/>
          <ac:spMkLst>
            <pc:docMk/>
            <pc:sldMk cId="2518644381" sldId="264"/>
            <ac:spMk id="26" creationId="{CE75ACAD-C553-1BB1-9B58-24763820D867}"/>
          </ac:spMkLst>
        </pc:spChg>
        <pc:spChg chg="add mod">
          <ac:chgData name="勇治 箱崎" userId="9db2de78f3965622" providerId="LiveId" clId="{56A87CB9-998E-4A09-8BA1-66EF0B8AA220}" dt="2025-05-17T22:23:51.748" v="642" actId="20577"/>
          <ac:spMkLst>
            <pc:docMk/>
            <pc:sldMk cId="2518644381" sldId="264"/>
            <ac:spMk id="27" creationId="{25DB4F7F-ACAF-7F22-1F76-7291D51065EF}"/>
          </ac:spMkLst>
        </pc:spChg>
        <pc:spChg chg="add mod">
          <ac:chgData name="勇治 箱崎" userId="9db2de78f3965622" providerId="LiveId" clId="{56A87CB9-998E-4A09-8BA1-66EF0B8AA220}" dt="2025-05-17T22:24:09.441" v="649" actId="20577"/>
          <ac:spMkLst>
            <pc:docMk/>
            <pc:sldMk cId="2518644381" sldId="264"/>
            <ac:spMk id="28" creationId="{803D9FED-50B3-EB48-D289-CB723BCF57CC}"/>
          </ac:spMkLst>
        </pc:spChg>
        <pc:spChg chg="add mod">
          <ac:chgData name="勇治 箱崎" userId="9db2de78f3965622" providerId="LiveId" clId="{56A87CB9-998E-4A09-8BA1-66EF0B8AA220}" dt="2025-05-17T22:24:20.293" v="653" actId="20577"/>
          <ac:spMkLst>
            <pc:docMk/>
            <pc:sldMk cId="2518644381" sldId="264"/>
            <ac:spMk id="29" creationId="{F3338059-A57D-1E8F-C5F3-04F645F7C52B}"/>
          </ac:spMkLst>
        </pc:spChg>
        <pc:spChg chg="add mod">
          <ac:chgData name="勇治 箱崎" userId="9db2de78f3965622" providerId="LiveId" clId="{56A87CB9-998E-4A09-8BA1-66EF0B8AA220}" dt="2025-05-17T22:24:29.112" v="661" actId="20577"/>
          <ac:spMkLst>
            <pc:docMk/>
            <pc:sldMk cId="2518644381" sldId="264"/>
            <ac:spMk id="30" creationId="{937FC487-7AFD-C5C0-AE65-01A55F76DE3C}"/>
          </ac:spMkLst>
        </pc:spChg>
        <pc:spChg chg="add mod">
          <ac:chgData name="勇治 箱崎" userId="9db2de78f3965622" providerId="LiveId" clId="{56A87CB9-998E-4A09-8BA1-66EF0B8AA220}" dt="2025-05-17T22:24:37.549" v="666" actId="20577"/>
          <ac:spMkLst>
            <pc:docMk/>
            <pc:sldMk cId="2518644381" sldId="264"/>
            <ac:spMk id="31" creationId="{7511CAB3-048A-32DC-D4CF-E4B1173A351E}"/>
          </ac:spMkLst>
        </pc:spChg>
        <pc:spChg chg="add mod">
          <ac:chgData name="勇治 箱崎" userId="9db2de78f3965622" providerId="LiveId" clId="{56A87CB9-998E-4A09-8BA1-66EF0B8AA220}" dt="2025-05-17T22:24:48.119" v="672" actId="20577"/>
          <ac:spMkLst>
            <pc:docMk/>
            <pc:sldMk cId="2518644381" sldId="264"/>
            <ac:spMk id="32" creationId="{125DC44B-414A-3EE2-F156-4FD7BADAD7E9}"/>
          </ac:spMkLst>
        </pc:spChg>
        <pc:spChg chg="add mod">
          <ac:chgData name="勇治 箱崎" userId="9db2de78f3965622" providerId="LiveId" clId="{56A87CB9-998E-4A09-8BA1-66EF0B8AA220}" dt="2025-05-17T22:24:59.380" v="678" actId="20577"/>
          <ac:spMkLst>
            <pc:docMk/>
            <pc:sldMk cId="2518644381" sldId="264"/>
            <ac:spMk id="33" creationId="{E4CB5B29-8097-99EB-A678-1F0C5831BF5A}"/>
          </ac:spMkLst>
        </pc:spChg>
        <pc:spChg chg="add mod">
          <ac:chgData name="勇治 箱崎" userId="9db2de78f3965622" providerId="LiveId" clId="{56A87CB9-998E-4A09-8BA1-66EF0B8AA220}" dt="2025-05-17T22:25:16.544" v="684" actId="1037"/>
          <ac:spMkLst>
            <pc:docMk/>
            <pc:sldMk cId="2518644381" sldId="264"/>
            <ac:spMk id="34" creationId="{CBBED98A-18C7-0A60-83B5-D496522C9190}"/>
          </ac:spMkLst>
        </pc:spChg>
        <pc:spChg chg="add mod">
          <ac:chgData name="勇治 箱崎" userId="9db2de78f3965622" providerId="LiveId" clId="{56A87CB9-998E-4A09-8BA1-66EF0B8AA220}" dt="2025-05-17T22:25:29.123" v="697" actId="1038"/>
          <ac:spMkLst>
            <pc:docMk/>
            <pc:sldMk cId="2518644381" sldId="264"/>
            <ac:spMk id="35" creationId="{C7B7A3A0-0E59-07A7-23A5-EFDA0CB45E91}"/>
          </ac:spMkLst>
        </pc:spChg>
        <pc:spChg chg="add mod">
          <ac:chgData name="勇治 箱崎" userId="9db2de78f3965622" providerId="LiveId" clId="{56A87CB9-998E-4A09-8BA1-66EF0B8AA220}" dt="2025-05-17T22:25:34.895" v="714" actId="1037"/>
          <ac:spMkLst>
            <pc:docMk/>
            <pc:sldMk cId="2518644381" sldId="264"/>
            <ac:spMk id="36" creationId="{3AAB79A9-F20B-C212-B278-4272A42342D8}"/>
          </ac:spMkLst>
        </pc:spChg>
        <pc:spChg chg="add mod">
          <ac:chgData name="勇治 箱崎" userId="9db2de78f3965622" providerId="LiveId" clId="{56A87CB9-998E-4A09-8BA1-66EF0B8AA220}" dt="2025-05-17T22:25:42.178" v="737" actId="1037"/>
          <ac:spMkLst>
            <pc:docMk/>
            <pc:sldMk cId="2518644381" sldId="264"/>
            <ac:spMk id="37" creationId="{A6A8989F-9BFF-7605-56C7-3B43298C2E99}"/>
          </ac:spMkLst>
        </pc:spChg>
        <pc:spChg chg="add mod">
          <ac:chgData name="勇治 箱崎" userId="9db2de78f3965622" providerId="LiveId" clId="{56A87CB9-998E-4A09-8BA1-66EF0B8AA220}" dt="2025-05-17T22:25:48.880" v="769" actId="1037"/>
          <ac:spMkLst>
            <pc:docMk/>
            <pc:sldMk cId="2518644381" sldId="264"/>
            <ac:spMk id="38" creationId="{8C681FE1-3C81-A4E6-CDBA-EC802D547703}"/>
          </ac:spMkLst>
        </pc:spChg>
        <pc:spChg chg="add mod">
          <ac:chgData name="勇治 箱崎" userId="9db2de78f3965622" providerId="LiveId" clId="{56A87CB9-998E-4A09-8BA1-66EF0B8AA220}" dt="2025-05-17T22:25:54.841" v="797" actId="1037"/>
          <ac:spMkLst>
            <pc:docMk/>
            <pc:sldMk cId="2518644381" sldId="264"/>
            <ac:spMk id="39" creationId="{B9F04D3B-9F00-BA4F-E88F-6EA1AEC7B82C}"/>
          </ac:spMkLst>
        </pc:spChg>
        <pc:spChg chg="add mod">
          <ac:chgData name="勇治 箱崎" userId="9db2de78f3965622" providerId="LiveId" clId="{56A87CB9-998E-4A09-8BA1-66EF0B8AA220}" dt="2025-05-17T22:26:02.111" v="832" actId="1038"/>
          <ac:spMkLst>
            <pc:docMk/>
            <pc:sldMk cId="2518644381" sldId="264"/>
            <ac:spMk id="40" creationId="{96FAECB8-474A-499B-F1E5-044451165082}"/>
          </ac:spMkLst>
        </pc:spChg>
        <pc:spChg chg="add mod">
          <ac:chgData name="勇治 箱崎" userId="9db2de78f3965622" providerId="LiveId" clId="{56A87CB9-998E-4A09-8BA1-66EF0B8AA220}" dt="2025-05-17T22:26:10.876" v="877" actId="1037"/>
          <ac:spMkLst>
            <pc:docMk/>
            <pc:sldMk cId="2518644381" sldId="264"/>
            <ac:spMk id="41" creationId="{96F3B5FF-C05E-5709-91C6-50F788E9F428}"/>
          </ac:spMkLst>
        </pc:spChg>
        <pc:spChg chg="add mod">
          <ac:chgData name="勇治 箱崎" userId="9db2de78f3965622" providerId="LiveId" clId="{56A87CB9-998E-4A09-8BA1-66EF0B8AA220}" dt="2025-05-17T22:26:17.745" v="917" actId="1038"/>
          <ac:spMkLst>
            <pc:docMk/>
            <pc:sldMk cId="2518644381" sldId="264"/>
            <ac:spMk id="42" creationId="{A0560917-0820-9F68-0546-A52F20A871AC}"/>
          </ac:spMkLst>
        </pc:spChg>
        <pc:spChg chg="add mod">
          <ac:chgData name="勇治 箱崎" userId="9db2de78f3965622" providerId="LiveId" clId="{56A87CB9-998E-4A09-8BA1-66EF0B8AA220}" dt="2025-05-17T22:26:27.247" v="966" actId="1038"/>
          <ac:spMkLst>
            <pc:docMk/>
            <pc:sldMk cId="2518644381" sldId="264"/>
            <ac:spMk id="43" creationId="{48EBD66B-8B01-505A-85A6-A62CC4DD32DE}"/>
          </ac:spMkLst>
        </pc:spChg>
        <pc:spChg chg="mod">
          <ac:chgData name="勇治 箱崎" userId="9db2de78f3965622" providerId="LiveId" clId="{56A87CB9-998E-4A09-8BA1-66EF0B8AA220}" dt="2025-05-17T22:26:34.069" v="1018" actId="1037"/>
          <ac:spMkLst>
            <pc:docMk/>
            <pc:sldMk cId="2518644381" sldId="264"/>
            <ac:spMk id="44" creationId="{0E90D8C8-9E4B-E512-FC53-8A1ADF8FBF51}"/>
          </ac:spMkLst>
        </pc:spChg>
        <pc:spChg chg="add mod">
          <ac:chgData name="勇治 箱崎" userId="9db2de78f3965622" providerId="LiveId" clId="{56A87CB9-998E-4A09-8BA1-66EF0B8AA220}" dt="2025-05-17T22:26:52.799" v="1026" actId="1038"/>
          <ac:spMkLst>
            <pc:docMk/>
            <pc:sldMk cId="2518644381" sldId="264"/>
            <ac:spMk id="45" creationId="{EE1B8EF3-F7CF-67DB-41F3-2F548DA3067A}"/>
          </ac:spMkLst>
        </pc:spChg>
        <pc:spChg chg="add mod">
          <ac:chgData name="勇治 箱崎" userId="9db2de78f3965622" providerId="LiveId" clId="{56A87CB9-998E-4A09-8BA1-66EF0B8AA220}" dt="2025-05-17T22:27:00.003" v="1030" actId="1038"/>
          <ac:spMkLst>
            <pc:docMk/>
            <pc:sldMk cId="2518644381" sldId="264"/>
            <ac:spMk id="46" creationId="{F0FFFE28-F1AA-FD70-424C-6F7ABA730C88}"/>
          </ac:spMkLst>
        </pc:spChg>
        <pc:spChg chg="add mod">
          <ac:chgData name="勇治 箱崎" userId="9db2de78f3965622" providerId="LiveId" clId="{56A87CB9-998E-4A09-8BA1-66EF0B8AA220}" dt="2025-05-17T22:27:08.053" v="1033" actId="1038"/>
          <ac:spMkLst>
            <pc:docMk/>
            <pc:sldMk cId="2518644381" sldId="264"/>
            <ac:spMk id="47" creationId="{6DDEAD8E-357E-62AD-E831-ECFFD3861333}"/>
          </ac:spMkLst>
        </pc:spChg>
        <pc:spChg chg="add mod">
          <ac:chgData name="勇治 箱崎" userId="9db2de78f3965622" providerId="LiveId" clId="{56A87CB9-998E-4A09-8BA1-66EF0B8AA220}" dt="2025-05-17T22:28:10.239" v="1098" actId="20577"/>
          <ac:spMkLst>
            <pc:docMk/>
            <pc:sldMk cId="2518644381" sldId="264"/>
            <ac:spMk id="56" creationId="{85AC40A1-5795-1CFE-8587-6DE0D12F9C6F}"/>
          </ac:spMkLst>
        </pc:spChg>
        <pc:spChg chg="add mod">
          <ac:chgData name="勇治 箱崎" userId="9db2de78f3965622" providerId="LiveId" clId="{56A87CB9-998E-4A09-8BA1-66EF0B8AA220}" dt="2025-05-17T22:28:11.783" v="1099" actId="20577"/>
          <ac:spMkLst>
            <pc:docMk/>
            <pc:sldMk cId="2518644381" sldId="264"/>
            <ac:spMk id="57" creationId="{D4E38689-D68B-211E-1D98-9CF09A34D111}"/>
          </ac:spMkLst>
        </pc:spChg>
        <pc:spChg chg="add mod">
          <ac:chgData name="勇治 箱崎" userId="9db2de78f3965622" providerId="LiveId" clId="{56A87CB9-998E-4A09-8BA1-66EF0B8AA220}" dt="2025-05-17T22:28:04.720" v="1097" actId="1038"/>
          <ac:spMkLst>
            <pc:docMk/>
            <pc:sldMk cId="2518644381" sldId="264"/>
            <ac:spMk id="58" creationId="{C4993223-2963-3343-E022-DFA21A7C1814}"/>
          </ac:spMkLst>
        </pc:spChg>
        <pc:spChg chg="add mod">
          <ac:chgData name="勇治 箱崎" userId="9db2de78f3965622" providerId="LiveId" clId="{56A87CB9-998E-4A09-8BA1-66EF0B8AA220}" dt="2025-05-17T22:28:24.584" v="1148" actId="1038"/>
          <ac:spMkLst>
            <pc:docMk/>
            <pc:sldMk cId="2518644381" sldId="264"/>
            <ac:spMk id="59" creationId="{CF9DB69A-E3AE-FD46-2215-CA2B6D3B9C5F}"/>
          </ac:spMkLst>
        </pc:spChg>
        <pc:spChg chg="add mod">
          <ac:chgData name="勇治 箱崎" userId="9db2de78f3965622" providerId="LiveId" clId="{56A87CB9-998E-4A09-8BA1-66EF0B8AA220}" dt="2025-05-17T22:28:37.114" v="1204" actId="1037"/>
          <ac:spMkLst>
            <pc:docMk/>
            <pc:sldMk cId="2518644381" sldId="264"/>
            <ac:spMk id="60" creationId="{935FFFEE-13F6-210D-9F94-109E0830BB21}"/>
          </ac:spMkLst>
        </pc:spChg>
        <pc:spChg chg="add mod">
          <ac:chgData name="勇治 箱崎" userId="9db2de78f3965622" providerId="LiveId" clId="{56A87CB9-998E-4A09-8BA1-66EF0B8AA220}" dt="2025-05-17T22:28:48.892" v="1265" actId="1037"/>
          <ac:spMkLst>
            <pc:docMk/>
            <pc:sldMk cId="2518644381" sldId="264"/>
            <ac:spMk id="61" creationId="{CC20FE3D-68CA-5A57-6BE9-7649F6D6D508}"/>
          </ac:spMkLst>
        </pc:spChg>
        <pc:spChg chg="add mod">
          <ac:chgData name="勇治 箱崎" userId="9db2de78f3965622" providerId="LiveId" clId="{56A87CB9-998E-4A09-8BA1-66EF0B8AA220}" dt="2025-05-17T22:28:58.215" v="1330" actId="1037"/>
          <ac:spMkLst>
            <pc:docMk/>
            <pc:sldMk cId="2518644381" sldId="264"/>
            <ac:spMk id="62" creationId="{7BEB870E-6A0D-144E-E211-A0A005544C12}"/>
          </ac:spMkLst>
        </pc:spChg>
        <pc:spChg chg="add mod">
          <ac:chgData name="勇治 箱崎" userId="9db2de78f3965622" providerId="LiveId" clId="{56A87CB9-998E-4A09-8BA1-66EF0B8AA220}" dt="2025-05-17T22:29:07.277" v="1398" actId="1037"/>
          <ac:spMkLst>
            <pc:docMk/>
            <pc:sldMk cId="2518644381" sldId="264"/>
            <ac:spMk id="63" creationId="{529002BE-D8F6-87F7-6A54-0531D12BBAB4}"/>
          </ac:spMkLst>
        </pc:spChg>
        <pc:spChg chg="add mod">
          <ac:chgData name="勇治 箱崎" userId="9db2de78f3965622" providerId="LiveId" clId="{56A87CB9-998E-4A09-8BA1-66EF0B8AA220}" dt="2025-05-17T22:29:47.282" v="1410" actId="20577"/>
          <ac:spMkLst>
            <pc:docMk/>
            <pc:sldMk cId="2518644381" sldId="264"/>
            <ac:spMk id="64" creationId="{23EA98BC-42E5-3B79-6C25-72FF0A2EC560}"/>
          </ac:spMkLst>
        </pc:spChg>
        <pc:spChg chg="add mod">
          <ac:chgData name="勇治 箱崎" userId="9db2de78f3965622" providerId="LiveId" clId="{56A87CB9-998E-4A09-8BA1-66EF0B8AA220}" dt="2025-05-17T22:29:59.415" v="1416" actId="20577"/>
          <ac:spMkLst>
            <pc:docMk/>
            <pc:sldMk cId="2518644381" sldId="264"/>
            <ac:spMk id="65" creationId="{8528A8C6-ED63-3DA2-D82C-91E2127411DC}"/>
          </ac:spMkLst>
        </pc:spChg>
        <pc:spChg chg="add mod">
          <ac:chgData name="勇治 箱崎" userId="9db2de78f3965622" providerId="LiveId" clId="{56A87CB9-998E-4A09-8BA1-66EF0B8AA220}" dt="2025-05-17T22:30:02.368" v="1420" actId="20577"/>
          <ac:spMkLst>
            <pc:docMk/>
            <pc:sldMk cId="2518644381" sldId="264"/>
            <ac:spMk id="66" creationId="{45030156-D21E-4755-5484-B051857A1644}"/>
          </ac:spMkLst>
        </pc:spChg>
        <pc:spChg chg="add mod">
          <ac:chgData name="勇治 箱崎" userId="9db2de78f3965622" providerId="LiveId" clId="{56A87CB9-998E-4A09-8BA1-66EF0B8AA220}" dt="2025-05-17T22:30:05.714" v="1424" actId="20577"/>
          <ac:spMkLst>
            <pc:docMk/>
            <pc:sldMk cId="2518644381" sldId="264"/>
            <ac:spMk id="67" creationId="{BA4A25AA-BEE6-ABA7-1232-8B7BAC589245}"/>
          </ac:spMkLst>
        </pc:spChg>
        <pc:spChg chg="add mod">
          <ac:chgData name="勇治 箱崎" userId="9db2de78f3965622" providerId="LiveId" clId="{56A87CB9-998E-4A09-8BA1-66EF0B8AA220}" dt="2025-05-17T22:30:09.218" v="1428" actId="20577"/>
          <ac:spMkLst>
            <pc:docMk/>
            <pc:sldMk cId="2518644381" sldId="264"/>
            <ac:spMk id="68" creationId="{C47F7362-5EC3-B5A0-518C-1CCD702AAED1}"/>
          </ac:spMkLst>
        </pc:spChg>
        <pc:spChg chg="add mod">
          <ac:chgData name="勇治 箱崎" userId="9db2de78f3965622" providerId="LiveId" clId="{56A87CB9-998E-4A09-8BA1-66EF0B8AA220}" dt="2025-05-17T22:30:33.647" v="1435" actId="1038"/>
          <ac:spMkLst>
            <pc:docMk/>
            <pc:sldMk cId="2518644381" sldId="264"/>
            <ac:spMk id="69" creationId="{19F1DA9B-DEC9-BF8B-7D70-7F15109B6C6A}"/>
          </ac:spMkLst>
        </pc:spChg>
        <pc:spChg chg="add mod">
          <ac:chgData name="勇治 箱崎" userId="9db2de78f3965622" providerId="LiveId" clId="{56A87CB9-998E-4A09-8BA1-66EF0B8AA220}" dt="2025-05-17T22:30:41.055" v="1459" actId="1037"/>
          <ac:spMkLst>
            <pc:docMk/>
            <pc:sldMk cId="2518644381" sldId="264"/>
            <ac:spMk id="70" creationId="{4AB2693F-695A-1DF6-B542-CC942C540951}"/>
          </ac:spMkLst>
        </pc:spChg>
        <pc:spChg chg="add mod">
          <ac:chgData name="勇治 箱崎" userId="9db2de78f3965622" providerId="LiveId" clId="{56A87CB9-998E-4A09-8BA1-66EF0B8AA220}" dt="2025-05-17T22:31:18.775" v="1487" actId="1038"/>
          <ac:spMkLst>
            <pc:docMk/>
            <pc:sldMk cId="2518644381" sldId="264"/>
            <ac:spMk id="71" creationId="{58FD1028-96CD-0641-BA4F-480AAAAFBB9D}"/>
          </ac:spMkLst>
        </pc:spChg>
        <pc:spChg chg="add mod">
          <ac:chgData name="勇治 箱崎" userId="9db2de78f3965622" providerId="LiveId" clId="{56A87CB9-998E-4A09-8BA1-66EF0B8AA220}" dt="2025-05-17T22:31:43.580" v="1498" actId="20577"/>
          <ac:spMkLst>
            <pc:docMk/>
            <pc:sldMk cId="2518644381" sldId="264"/>
            <ac:spMk id="80" creationId="{87761DC5-6AE9-4A83-0956-229637E1589A}"/>
          </ac:spMkLst>
        </pc:spChg>
        <pc:spChg chg="add mod">
          <ac:chgData name="勇治 箱崎" userId="9db2de78f3965622" providerId="LiveId" clId="{56A87CB9-998E-4A09-8BA1-66EF0B8AA220}" dt="2025-05-17T22:31:53.214" v="1502" actId="20577"/>
          <ac:spMkLst>
            <pc:docMk/>
            <pc:sldMk cId="2518644381" sldId="264"/>
            <ac:spMk id="81" creationId="{A2C8DF0F-8A97-85FF-E094-B66BF0CD5065}"/>
          </ac:spMkLst>
        </pc:spChg>
        <pc:spChg chg="add mod">
          <ac:chgData name="勇治 箱崎" userId="9db2de78f3965622" providerId="LiveId" clId="{56A87CB9-998E-4A09-8BA1-66EF0B8AA220}" dt="2025-05-17T22:32:02.282" v="1509" actId="20577"/>
          <ac:spMkLst>
            <pc:docMk/>
            <pc:sldMk cId="2518644381" sldId="264"/>
            <ac:spMk id="82" creationId="{D360DF6E-B174-F393-D21B-ABECFAE4B381}"/>
          </ac:spMkLst>
        </pc:spChg>
        <pc:spChg chg="add mod">
          <ac:chgData name="勇治 箱崎" userId="9db2de78f3965622" providerId="LiveId" clId="{56A87CB9-998E-4A09-8BA1-66EF0B8AA220}" dt="2025-05-17T22:32:26.784" v="1516" actId="1038"/>
          <ac:spMkLst>
            <pc:docMk/>
            <pc:sldMk cId="2518644381" sldId="264"/>
            <ac:spMk id="83" creationId="{1EB652BA-B0C2-22A1-050A-579646BD82CA}"/>
          </ac:spMkLst>
        </pc:spChg>
        <pc:spChg chg="add mod">
          <ac:chgData name="勇治 箱崎" userId="9db2de78f3965622" providerId="LiveId" clId="{56A87CB9-998E-4A09-8BA1-66EF0B8AA220}" dt="2025-05-17T22:32:31.397" v="1521" actId="1038"/>
          <ac:spMkLst>
            <pc:docMk/>
            <pc:sldMk cId="2518644381" sldId="264"/>
            <ac:spMk id="84" creationId="{C2B93047-962D-AD70-5865-2C0CC9531263}"/>
          </ac:spMkLst>
        </pc:spChg>
        <pc:spChg chg="add mod">
          <ac:chgData name="勇治 箱崎" userId="9db2de78f3965622" providerId="LiveId" clId="{56A87CB9-998E-4A09-8BA1-66EF0B8AA220}" dt="2025-05-17T22:32:37.613" v="1537" actId="1037"/>
          <ac:spMkLst>
            <pc:docMk/>
            <pc:sldMk cId="2518644381" sldId="264"/>
            <ac:spMk id="85" creationId="{09073730-CB64-3FA6-37F4-4F9116F43C7D}"/>
          </ac:spMkLst>
        </pc:spChg>
        <pc:spChg chg="add mod">
          <ac:chgData name="勇治 箱崎" userId="9db2de78f3965622" providerId="LiveId" clId="{56A87CB9-998E-4A09-8BA1-66EF0B8AA220}" dt="2025-05-17T22:33:13.931" v="1540" actId="20577"/>
          <ac:spMkLst>
            <pc:docMk/>
            <pc:sldMk cId="2518644381" sldId="264"/>
            <ac:spMk id="86" creationId="{5572369C-F053-18F0-AC62-28A52EF69E0E}"/>
          </ac:spMkLst>
        </pc:spChg>
        <pc:spChg chg="add mod">
          <ac:chgData name="勇治 箱崎" userId="9db2de78f3965622" providerId="LiveId" clId="{56A87CB9-998E-4A09-8BA1-66EF0B8AA220}" dt="2025-05-19T15:42:24.388" v="2095" actId="1037"/>
          <ac:spMkLst>
            <pc:docMk/>
            <pc:sldMk cId="2518644381" sldId="264"/>
            <ac:spMk id="89" creationId="{5BFEB4DD-9B36-7CC9-B749-677FBF3268B4}"/>
          </ac:spMkLst>
        </pc:spChg>
        <pc:spChg chg="add mod">
          <ac:chgData name="勇治 箱崎" userId="9db2de78f3965622" providerId="LiveId" clId="{56A87CB9-998E-4A09-8BA1-66EF0B8AA220}" dt="2025-05-19T15:42:24.388" v="2095" actId="1037"/>
          <ac:spMkLst>
            <pc:docMk/>
            <pc:sldMk cId="2518644381" sldId="264"/>
            <ac:spMk id="90" creationId="{9F690DC0-1F6F-E4E1-FBBB-882452031B98}"/>
          </ac:spMkLst>
        </pc:spChg>
        <pc:spChg chg="add mod">
          <ac:chgData name="勇治 箱崎" userId="9db2de78f3965622" providerId="LiveId" clId="{56A87CB9-998E-4A09-8BA1-66EF0B8AA220}" dt="2025-05-19T15:42:24.388" v="2095" actId="1037"/>
          <ac:spMkLst>
            <pc:docMk/>
            <pc:sldMk cId="2518644381" sldId="264"/>
            <ac:spMk id="91" creationId="{8D7A8347-AFDD-01B0-9782-6B8FC8DE7FC7}"/>
          </ac:spMkLst>
        </pc:spChg>
        <pc:spChg chg="add mod">
          <ac:chgData name="勇治 箱崎" userId="9db2de78f3965622" providerId="LiveId" clId="{56A87CB9-998E-4A09-8BA1-66EF0B8AA220}" dt="2025-05-19T15:42:24.388" v="2095" actId="1037"/>
          <ac:spMkLst>
            <pc:docMk/>
            <pc:sldMk cId="2518644381" sldId="264"/>
            <ac:spMk id="92" creationId="{16A92269-3C6A-C311-728F-51B4C0B58ED0}"/>
          </ac:spMkLst>
        </pc:spChg>
        <pc:spChg chg="add mod">
          <ac:chgData name="勇治 箱崎" userId="9db2de78f3965622" providerId="LiveId" clId="{56A87CB9-998E-4A09-8BA1-66EF0B8AA220}" dt="2025-05-19T15:42:30.546" v="2103" actId="1035"/>
          <ac:spMkLst>
            <pc:docMk/>
            <pc:sldMk cId="2518644381" sldId="264"/>
            <ac:spMk id="93" creationId="{84E478F0-56BB-FF6B-1474-F36B7FE6B843}"/>
          </ac:spMkLst>
        </pc:spChg>
        <pc:spChg chg="add mod">
          <ac:chgData name="勇治 箱崎" userId="9db2de78f3965622" providerId="LiveId" clId="{56A87CB9-998E-4A09-8BA1-66EF0B8AA220}" dt="2025-05-17T22:40:32.432" v="1928" actId="1037"/>
          <ac:spMkLst>
            <pc:docMk/>
            <pc:sldMk cId="2518644381" sldId="264"/>
            <ac:spMk id="95" creationId="{096BD203-CB05-CF37-9BC4-4F6010B3F081}"/>
          </ac:spMkLst>
        </pc:spChg>
        <pc:spChg chg="add mod">
          <ac:chgData name="勇治 箱崎" userId="9db2de78f3965622" providerId="LiveId" clId="{56A87CB9-998E-4A09-8BA1-66EF0B8AA220}" dt="2025-05-19T15:42:07.205" v="2085" actId="1038"/>
          <ac:spMkLst>
            <pc:docMk/>
            <pc:sldMk cId="2518644381" sldId="264"/>
            <ac:spMk id="96" creationId="{C0762E50-A4D5-BB5C-E75D-DD14B74CA805}"/>
          </ac:spMkLst>
        </pc:spChg>
        <pc:spChg chg="add mod">
          <ac:chgData name="勇治 箱崎" userId="9db2de78f3965622" providerId="LiveId" clId="{56A87CB9-998E-4A09-8BA1-66EF0B8AA220}" dt="2025-05-19T15:42:02.753" v="2078" actId="1037"/>
          <ac:spMkLst>
            <pc:docMk/>
            <pc:sldMk cId="2518644381" sldId="264"/>
            <ac:spMk id="97" creationId="{69874A50-C2E6-C3E3-CEB5-22D7C03FAF87}"/>
          </ac:spMkLst>
        </pc:spChg>
        <pc:spChg chg="add mod">
          <ac:chgData name="勇治 箱崎" userId="9db2de78f3965622" providerId="LiveId" clId="{56A87CB9-998E-4A09-8BA1-66EF0B8AA220}" dt="2025-05-19T15:41:57.744" v="2070" actId="1038"/>
          <ac:spMkLst>
            <pc:docMk/>
            <pc:sldMk cId="2518644381" sldId="264"/>
            <ac:spMk id="98" creationId="{70441D8C-57BD-19D0-1B80-BE6278EB92E0}"/>
          </ac:spMkLst>
        </pc:spChg>
        <pc:spChg chg="add mod">
          <ac:chgData name="勇治 箱崎" userId="9db2de78f3965622" providerId="LiveId" clId="{56A87CB9-998E-4A09-8BA1-66EF0B8AA220}" dt="2025-05-17T22:38:57.174" v="1783" actId="1036"/>
          <ac:spMkLst>
            <pc:docMk/>
            <pc:sldMk cId="2518644381" sldId="264"/>
            <ac:spMk id="99" creationId="{1ECC0C57-3151-FFB3-D22E-64CC592537E8}"/>
          </ac:spMkLst>
        </pc:spChg>
        <pc:spChg chg="add mod">
          <ac:chgData name="勇治 箱崎" userId="9db2de78f3965622" providerId="LiveId" clId="{56A87CB9-998E-4A09-8BA1-66EF0B8AA220}" dt="2025-05-19T15:42:16.695" v="2089" actId="1037"/>
          <ac:spMkLst>
            <pc:docMk/>
            <pc:sldMk cId="2518644381" sldId="264"/>
            <ac:spMk id="101" creationId="{B0A5A51A-C75F-17FE-2949-A0309FA0AB19}"/>
          </ac:spMkLst>
        </pc:spChg>
        <pc:spChg chg="add mod">
          <ac:chgData name="勇治 箱崎" userId="9db2de78f3965622" providerId="LiveId" clId="{56A87CB9-998E-4A09-8BA1-66EF0B8AA220}" dt="2025-05-19T15:39:12.741" v="2009" actId="20577"/>
          <ac:spMkLst>
            <pc:docMk/>
            <pc:sldMk cId="2518644381" sldId="264"/>
            <ac:spMk id="102" creationId="{F6655B68-B709-B906-4539-0FAA41067C1C}"/>
          </ac:spMkLst>
        </pc:spChg>
        <pc:picChg chg="mod ord modCrop">
          <ac:chgData name="勇治 箱崎" userId="9db2de78f3965622" providerId="LiveId" clId="{56A87CB9-998E-4A09-8BA1-66EF0B8AA220}" dt="2025-05-17T22:27:26.037" v="1036" actId="1076"/>
          <ac:picMkLst>
            <pc:docMk/>
            <pc:sldMk cId="2518644381" sldId="264"/>
            <ac:picMk id="4" creationId="{2A16AFAB-BFAF-0991-1839-07D844B65BA0}"/>
          </ac:picMkLst>
        </pc:picChg>
        <pc:picChg chg="mod ord modCrop">
          <ac:chgData name="勇治 箱崎" userId="9db2de78f3965622" providerId="LiveId" clId="{56A87CB9-998E-4A09-8BA1-66EF0B8AA220}" dt="2025-05-19T15:41:51.897" v="2067" actId="1037"/>
          <ac:picMkLst>
            <pc:docMk/>
            <pc:sldMk cId="2518644381" sldId="264"/>
            <ac:picMk id="7" creationId="{069C4811-C185-A719-27BC-DF39EAEDC76C}"/>
          </ac:picMkLst>
        </pc:picChg>
        <pc:picChg chg="del mod ord modCrop">
          <ac:chgData name="勇治 箱崎" userId="9db2de78f3965622" providerId="LiveId" clId="{56A87CB9-998E-4A09-8BA1-66EF0B8AA220}" dt="2025-05-19T15:41:13.416" v="2031" actId="478"/>
          <ac:picMkLst>
            <pc:docMk/>
            <pc:sldMk cId="2518644381" sldId="264"/>
            <ac:picMk id="94" creationId="{8F9D49B4-71DA-EEA2-26CC-E3A1CB911630}"/>
          </ac:picMkLst>
        </pc:picChg>
      </pc:sldChg>
    </pc:docChg>
  </pc:docChgLst>
  <pc:docChgLst>
    <pc:chgData name="勇治 箱崎" userId="9db2de78f3965622" providerId="LiveId" clId="{B3915A97-9029-42FE-9EB5-D2E633A49F2C}"/>
    <pc:docChg chg="undo custSel modSld">
      <pc:chgData name="勇治 箱崎" userId="9db2de78f3965622" providerId="LiveId" clId="{B3915A97-9029-42FE-9EB5-D2E633A49F2C}" dt="2025-03-01T12:09:22.168" v="351" actId="1036"/>
      <pc:docMkLst>
        <pc:docMk/>
      </pc:docMkLst>
      <pc:sldChg chg="addSp delSp modSp mod">
        <pc:chgData name="勇治 箱崎" userId="9db2de78f3965622" providerId="LiveId" clId="{B3915A97-9029-42FE-9EB5-D2E633A49F2C}" dt="2025-03-01T12:04:47.928" v="270" actId="14100"/>
        <pc:sldMkLst>
          <pc:docMk/>
          <pc:sldMk cId="692380640" sldId="259"/>
        </pc:sldMkLst>
      </pc:sldChg>
      <pc:sldChg chg="modSp mod">
        <pc:chgData name="勇治 箱崎" userId="9db2de78f3965622" providerId="LiveId" clId="{B3915A97-9029-42FE-9EB5-D2E633A49F2C}" dt="2025-02-19T15:00:10.013" v="19" actId="113"/>
        <pc:sldMkLst>
          <pc:docMk/>
          <pc:sldMk cId="594557811" sldId="261"/>
        </pc:sldMkLst>
      </pc:sldChg>
      <pc:sldChg chg="addSp delSp modSp mod">
        <pc:chgData name="勇治 箱崎" userId="9db2de78f3965622" providerId="LiveId" clId="{B3915A97-9029-42FE-9EB5-D2E633A49F2C}" dt="2025-03-01T12:09:22.168" v="351" actId="1036"/>
        <pc:sldMkLst>
          <pc:docMk/>
          <pc:sldMk cId="2705313201" sldId="263"/>
        </pc:sldMkLst>
        <pc:spChg chg="mod">
          <ac:chgData name="勇治 箱崎" userId="9db2de78f3965622" providerId="LiveId" clId="{B3915A97-9029-42FE-9EB5-D2E633A49F2C}" dt="2025-03-01T11:33:04.148" v="166" actId="1035"/>
          <ac:spMkLst>
            <pc:docMk/>
            <pc:sldMk cId="2705313201" sldId="263"/>
            <ac:spMk id="5" creationId="{21400891-1D9D-57D0-C1E4-08F21DDADCD2}"/>
          </ac:spMkLst>
        </pc:spChg>
        <pc:spChg chg="mod">
          <ac:chgData name="勇治 箱崎" userId="9db2de78f3965622" providerId="LiveId" clId="{B3915A97-9029-42FE-9EB5-D2E633A49F2C}" dt="2025-03-01T11:33:08.804" v="168" actId="1036"/>
          <ac:spMkLst>
            <pc:docMk/>
            <pc:sldMk cId="2705313201" sldId="263"/>
            <ac:spMk id="6" creationId="{6F330269-B64C-2499-7D26-C5FBA5292F68}"/>
          </ac:spMkLst>
        </pc:spChg>
        <pc:spChg chg="mod">
          <ac:chgData name="勇治 箱崎" userId="9db2de78f3965622" providerId="LiveId" clId="{B3915A97-9029-42FE-9EB5-D2E633A49F2C}" dt="2025-02-19T15:00:23.431" v="23" actId="113"/>
          <ac:spMkLst>
            <pc:docMk/>
            <pc:sldMk cId="2705313201" sldId="263"/>
            <ac:spMk id="11" creationId="{0E325283-1FEB-C872-5E1C-4F54076163DB}"/>
          </ac:spMkLst>
        </pc:spChg>
        <pc:spChg chg="mod">
          <ac:chgData name="勇治 箱崎" userId="9db2de78f3965622" providerId="LiveId" clId="{B3915A97-9029-42FE-9EB5-D2E633A49F2C}" dt="2025-03-01T11:33:12.169" v="171" actId="1036"/>
          <ac:spMkLst>
            <pc:docMk/>
            <pc:sldMk cId="2705313201" sldId="263"/>
            <ac:spMk id="16" creationId="{E0F5CED5-5023-A9AE-1454-0624890F7321}"/>
          </ac:spMkLst>
        </pc:spChg>
        <pc:spChg chg="mod">
          <ac:chgData name="勇治 箱崎" userId="9db2de78f3965622" providerId="LiveId" clId="{B3915A97-9029-42FE-9EB5-D2E633A49F2C}" dt="2025-03-01T12:06:43.467" v="299" actId="20577"/>
          <ac:spMkLst>
            <pc:docMk/>
            <pc:sldMk cId="2705313201" sldId="263"/>
            <ac:spMk id="23" creationId="{95E9C60E-A0C3-3896-E075-6CC9AB8AABD2}"/>
          </ac:spMkLst>
        </pc:spChg>
        <pc:spChg chg="mod">
          <ac:chgData name="勇治 箱崎" userId="9db2de78f3965622" providerId="LiveId" clId="{B3915A97-9029-42FE-9EB5-D2E633A49F2C}" dt="2025-03-01T12:06:49.708" v="305" actId="20577"/>
          <ac:spMkLst>
            <pc:docMk/>
            <pc:sldMk cId="2705313201" sldId="263"/>
            <ac:spMk id="27" creationId="{A3BCCC3E-B22A-B13E-9D19-8D04E5022720}"/>
          </ac:spMkLst>
        </pc:spChg>
        <pc:spChg chg="mod">
          <ac:chgData name="勇治 箱崎" userId="9db2de78f3965622" providerId="LiveId" clId="{B3915A97-9029-42FE-9EB5-D2E633A49F2C}" dt="2025-03-01T12:06:55.462" v="313" actId="20577"/>
          <ac:spMkLst>
            <pc:docMk/>
            <pc:sldMk cId="2705313201" sldId="263"/>
            <ac:spMk id="28" creationId="{51A4202F-0E2D-33C9-7612-16327AC35787}"/>
          </ac:spMkLst>
        </pc:spChg>
        <pc:spChg chg="mod">
          <ac:chgData name="勇治 箱崎" userId="9db2de78f3965622" providerId="LiveId" clId="{B3915A97-9029-42FE-9EB5-D2E633A49F2C}" dt="2025-03-01T12:07:02.165" v="317" actId="20577"/>
          <ac:spMkLst>
            <pc:docMk/>
            <pc:sldMk cId="2705313201" sldId="263"/>
            <ac:spMk id="29" creationId="{F72BFF46-D68B-AE0E-2228-BDB9CD5EAA5C}"/>
          </ac:spMkLst>
        </pc:spChg>
        <pc:spChg chg="mod">
          <ac:chgData name="勇治 箱崎" userId="9db2de78f3965622" providerId="LiveId" clId="{B3915A97-9029-42FE-9EB5-D2E633A49F2C}" dt="2025-03-01T12:07:06.729" v="321" actId="20577"/>
          <ac:spMkLst>
            <pc:docMk/>
            <pc:sldMk cId="2705313201" sldId="263"/>
            <ac:spMk id="30" creationId="{A099BE87-66F8-2366-D01D-76E4CE8E9DEF}"/>
          </ac:spMkLst>
        </pc:spChg>
        <pc:spChg chg="mod">
          <ac:chgData name="勇治 箱崎" userId="9db2de78f3965622" providerId="LiveId" clId="{B3915A97-9029-42FE-9EB5-D2E633A49F2C}" dt="2025-03-01T12:06:26.816" v="281" actId="20577"/>
          <ac:spMkLst>
            <pc:docMk/>
            <pc:sldMk cId="2705313201" sldId="263"/>
            <ac:spMk id="65" creationId="{A7FFEC79-F972-4F85-DC8A-5247B31B8083}"/>
          </ac:spMkLst>
        </pc:spChg>
        <pc:spChg chg="mod">
          <ac:chgData name="勇治 箱崎" userId="9db2de78f3965622" providerId="LiveId" clId="{B3915A97-9029-42FE-9EB5-D2E633A49F2C}" dt="2025-03-01T12:06:38.004" v="293" actId="20577"/>
          <ac:spMkLst>
            <pc:docMk/>
            <pc:sldMk cId="2705313201" sldId="263"/>
            <ac:spMk id="68" creationId="{2717C348-174E-1BA2-141B-6EB4B3245BF2}"/>
          </ac:spMkLst>
        </pc:spChg>
        <pc:picChg chg="add mod ord modCrop">
          <ac:chgData name="勇治 箱崎" userId="9db2de78f3965622" providerId="LiveId" clId="{B3915A97-9029-42FE-9EB5-D2E633A49F2C}" dt="2025-03-01T12:09:22.168" v="351" actId="1036"/>
          <ac:picMkLst>
            <pc:docMk/>
            <pc:sldMk cId="2705313201" sldId="263"/>
            <ac:picMk id="13" creationId="{A19E6A08-EA61-7F9A-94C0-A6FEE195B2C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8275A6-89D6-4ED8-A655-E3C94C36500F}" type="datetimeFigureOut">
              <a:rPr kumimoji="1" lang="ja-JP" altLang="en-US" smtClean="0"/>
              <a:t>2025/5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855788" y="1233488"/>
            <a:ext cx="302418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9691"/>
            <a:ext cx="5388610" cy="388611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FF1860-DE20-482A-A67D-C519290DA6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52570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1pPr>
    <a:lvl2pPr marL="457164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2pPr>
    <a:lvl3pPr marL="914329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3pPr>
    <a:lvl4pPr marL="1371493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4pPr>
    <a:lvl5pPr marL="1828656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5pPr>
    <a:lvl6pPr marL="2285821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6pPr>
    <a:lvl7pPr marL="2742985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7pPr>
    <a:lvl8pPr marL="3200150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8pPr>
    <a:lvl9pPr marL="3657314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7082" y="1122363"/>
            <a:ext cx="5293599" cy="2387600"/>
          </a:xfrm>
        </p:spPr>
        <p:txBody>
          <a:bodyPr anchor="b"/>
          <a:lstStyle>
            <a:lvl1pPr algn="ctr">
              <a:defRPr sz="4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8471" y="3602038"/>
            <a:ext cx="4670822" cy="1655762"/>
          </a:xfrm>
        </p:spPr>
        <p:txBody>
          <a:bodyPr/>
          <a:lstStyle>
            <a:lvl1pPr marL="0" indent="0" algn="ctr">
              <a:buNone/>
              <a:defRPr sz="1635"/>
            </a:lvl1pPr>
            <a:lvl2pPr marL="311399" indent="0" algn="ctr">
              <a:buNone/>
              <a:defRPr sz="1362"/>
            </a:lvl2pPr>
            <a:lvl3pPr marL="622798" indent="0" algn="ctr">
              <a:buNone/>
              <a:defRPr sz="1226"/>
            </a:lvl3pPr>
            <a:lvl4pPr marL="934197" indent="0" algn="ctr">
              <a:buNone/>
              <a:defRPr sz="1090"/>
            </a:lvl4pPr>
            <a:lvl5pPr marL="1245596" indent="0" algn="ctr">
              <a:buNone/>
              <a:defRPr sz="1090"/>
            </a:lvl5pPr>
            <a:lvl6pPr marL="1556995" indent="0" algn="ctr">
              <a:buNone/>
              <a:defRPr sz="1090"/>
            </a:lvl6pPr>
            <a:lvl7pPr marL="1868394" indent="0" algn="ctr">
              <a:buNone/>
              <a:defRPr sz="1090"/>
            </a:lvl7pPr>
            <a:lvl8pPr marL="2179792" indent="0" algn="ctr">
              <a:buNone/>
              <a:defRPr sz="1090"/>
            </a:lvl8pPr>
            <a:lvl9pPr marL="2491191" indent="0" algn="ctr">
              <a:buNone/>
              <a:defRPr sz="109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5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34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5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6196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56743" y="365125"/>
            <a:ext cx="134286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8159" y="365125"/>
            <a:ext cx="3950737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5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4011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5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7909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915" y="1709740"/>
            <a:ext cx="5371446" cy="2852737"/>
          </a:xfrm>
        </p:spPr>
        <p:txBody>
          <a:bodyPr anchor="b"/>
          <a:lstStyle>
            <a:lvl1pPr>
              <a:defRPr sz="4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915" y="4589465"/>
            <a:ext cx="5371446" cy="1500187"/>
          </a:xfrm>
        </p:spPr>
        <p:txBody>
          <a:bodyPr/>
          <a:lstStyle>
            <a:lvl1pPr marL="0" indent="0">
              <a:buNone/>
              <a:defRPr sz="1635">
                <a:solidFill>
                  <a:schemeClr val="tx1"/>
                </a:solidFill>
              </a:defRPr>
            </a:lvl1pPr>
            <a:lvl2pPr marL="311399" indent="0">
              <a:buNone/>
              <a:defRPr sz="1362">
                <a:solidFill>
                  <a:schemeClr val="tx1">
                    <a:tint val="75000"/>
                  </a:schemeClr>
                </a:solidFill>
              </a:defRPr>
            </a:lvl2pPr>
            <a:lvl3pPr marL="622798" indent="0">
              <a:buNone/>
              <a:defRPr sz="1226">
                <a:solidFill>
                  <a:schemeClr val="tx1">
                    <a:tint val="75000"/>
                  </a:schemeClr>
                </a:solidFill>
              </a:defRPr>
            </a:lvl3pPr>
            <a:lvl4pPr marL="934197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4pPr>
            <a:lvl5pPr marL="1245596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5pPr>
            <a:lvl6pPr marL="1556995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6pPr>
            <a:lvl7pPr marL="1868394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7pPr>
            <a:lvl8pPr marL="2179792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8pPr>
            <a:lvl9pPr marL="2491191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5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9908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8159" y="1825625"/>
            <a:ext cx="2646799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52805" y="1825625"/>
            <a:ext cx="2646799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5/5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311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365127"/>
            <a:ext cx="5371446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971" y="1681163"/>
            <a:ext cx="2634635" cy="823912"/>
          </a:xfrm>
        </p:spPr>
        <p:txBody>
          <a:bodyPr anchor="b"/>
          <a:lstStyle>
            <a:lvl1pPr marL="0" indent="0">
              <a:buNone/>
              <a:defRPr sz="1635" b="1"/>
            </a:lvl1pPr>
            <a:lvl2pPr marL="311399" indent="0">
              <a:buNone/>
              <a:defRPr sz="1362" b="1"/>
            </a:lvl2pPr>
            <a:lvl3pPr marL="622798" indent="0">
              <a:buNone/>
              <a:defRPr sz="1226" b="1"/>
            </a:lvl3pPr>
            <a:lvl4pPr marL="934197" indent="0">
              <a:buNone/>
              <a:defRPr sz="1090" b="1"/>
            </a:lvl4pPr>
            <a:lvl5pPr marL="1245596" indent="0">
              <a:buNone/>
              <a:defRPr sz="1090" b="1"/>
            </a:lvl5pPr>
            <a:lvl6pPr marL="1556995" indent="0">
              <a:buNone/>
              <a:defRPr sz="1090" b="1"/>
            </a:lvl6pPr>
            <a:lvl7pPr marL="1868394" indent="0">
              <a:buNone/>
              <a:defRPr sz="1090" b="1"/>
            </a:lvl7pPr>
            <a:lvl8pPr marL="2179792" indent="0">
              <a:buNone/>
              <a:defRPr sz="1090" b="1"/>
            </a:lvl8pPr>
            <a:lvl9pPr marL="2491191" indent="0">
              <a:buNone/>
              <a:defRPr sz="109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971" y="2505075"/>
            <a:ext cx="2634635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52806" y="1681163"/>
            <a:ext cx="2647610" cy="823912"/>
          </a:xfrm>
        </p:spPr>
        <p:txBody>
          <a:bodyPr anchor="b"/>
          <a:lstStyle>
            <a:lvl1pPr marL="0" indent="0">
              <a:buNone/>
              <a:defRPr sz="1635" b="1"/>
            </a:lvl1pPr>
            <a:lvl2pPr marL="311399" indent="0">
              <a:buNone/>
              <a:defRPr sz="1362" b="1"/>
            </a:lvl2pPr>
            <a:lvl3pPr marL="622798" indent="0">
              <a:buNone/>
              <a:defRPr sz="1226" b="1"/>
            </a:lvl3pPr>
            <a:lvl4pPr marL="934197" indent="0">
              <a:buNone/>
              <a:defRPr sz="1090" b="1"/>
            </a:lvl4pPr>
            <a:lvl5pPr marL="1245596" indent="0">
              <a:buNone/>
              <a:defRPr sz="1090" b="1"/>
            </a:lvl5pPr>
            <a:lvl6pPr marL="1556995" indent="0">
              <a:buNone/>
              <a:defRPr sz="1090" b="1"/>
            </a:lvl6pPr>
            <a:lvl7pPr marL="1868394" indent="0">
              <a:buNone/>
              <a:defRPr sz="1090" b="1"/>
            </a:lvl7pPr>
            <a:lvl8pPr marL="2179792" indent="0">
              <a:buNone/>
              <a:defRPr sz="1090" b="1"/>
            </a:lvl8pPr>
            <a:lvl9pPr marL="2491191" indent="0">
              <a:buNone/>
              <a:defRPr sz="109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52806" y="2505075"/>
            <a:ext cx="264761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5/5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3056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5/5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4263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5/5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2202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457200"/>
            <a:ext cx="2008616" cy="1600200"/>
          </a:xfrm>
        </p:spPr>
        <p:txBody>
          <a:bodyPr anchor="b"/>
          <a:lstStyle>
            <a:lvl1pPr>
              <a:defRPr sz="21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7610" y="987427"/>
            <a:ext cx="3152805" cy="4873625"/>
          </a:xfrm>
        </p:spPr>
        <p:txBody>
          <a:bodyPr/>
          <a:lstStyle>
            <a:lvl1pPr>
              <a:defRPr sz="2180"/>
            </a:lvl1pPr>
            <a:lvl2pPr>
              <a:defRPr sz="1907"/>
            </a:lvl2pPr>
            <a:lvl3pPr>
              <a:defRPr sz="1635"/>
            </a:lvl3pPr>
            <a:lvl4pPr>
              <a:defRPr sz="1362"/>
            </a:lvl4pPr>
            <a:lvl5pPr>
              <a:defRPr sz="1362"/>
            </a:lvl5pPr>
            <a:lvl6pPr>
              <a:defRPr sz="1362"/>
            </a:lvl6pPr>
            <a:lvl7pPr>
              <a:defRPr sz="1362"/>
            </a:lvl7pPr>
            <a:lvl8pPr>
              <a:defRPr sz="1362"/>
            </a:lvl8pPr>
            <a:lvl9pPr>
              <a:defRPr sz="136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970" y="2057400"/>
            <a:ext cx="2008616" cy="3811588"/>
          </a:xfrm>
        </p:spPr>
        <p:txBody>
          <a:bodyPr/>
          <a:lstStyle>
            <a:lvl1pPr marL="0" indent="0">
              <a:buNone/>
              <a:defRPr sz="1090"/>
            </a:lvl1pPr>
            <a:lvl2pPr marL="311399" indent="0">
              <a:buNone/>
              <a:defRPr sz="954"/>
            </a:lvl2pPr>
            <a:lvl3pPr marL="622798" indent="0">
              <a:buNone/>
              <a:defRPr sz="817"/>
            </a:lvl3pPr>
            <a:lvl4pPr marL="934197" indent="0">
              <a:buNone/>
              <a:defRPr sz="681"/>
            </a:lvl4pPr>
            <a:lvl5pPr marL="1245596" indent="0">
              <a:buNone/>
              <a:defRPr sz="681"/>
            </a:lvl5pPr>
            <a:lvl6pPr marL="1556995" indent="0">
              <a:buNone/>
              <a:defRPr sz="681"/>
            </a:lvl6pPr>
            <a:lvl7pPr marL="1868394" indent="0">
              <a:buNone/>
              <a:defRPr sz="681"/>
            </a:lvl7pPr>
            <a:lvl8pPr marL="2179792" indent="0">
              <a:buNone/>
              <a:defRPr sz="681"/>
            </a:lvl8pPr>
            <a:lvl9pPr marL="2491191" indent="0">
              <a:buNone/>
              <a:defRPr sz="6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5/5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659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457200"/>
            <a:ext cx="2008616" cy="1600200"/>
          </a:xfrm>
        </p:spPr>
        <p:txBody>
          <a:bodyPr anchor="b"/>
          <a:lstStyle>
            <a:lvl1pPr>
              <a:defRPr sz="21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7610" y="987427"/>
            <a:ext cx="3152805" cy="4873625"/>
          </a:xfrm>
        </p:spPr>
        <p:txBody>
          <a:bodyPr anchor="t"/>
          <a:lstStyle>
            <a:lvl1pPr marL="0" indent="0">
              <a:buNone/>
              <a:defRPr sz="2180"/>
            </a:lvl1pPr>
            <a:lvl2pPr marL="311399" indent="0">
              <a:buNone/>
              <a:defRPr sz="1907"/>
            </a:lvl2pPr>
            <a:lvl3pPr marL="622798" indent="0">
              <a:buNone/>
              <a:defRPr sz="1635"/>
            </a:lvl3pPr>
            <a:lvl4pPr marL="934197" indent="0">
              <a:buNone/>
              <a:defRPr sz="1362"/>
            </a:lvl4pPr>
            <a:lvl5pPr marL="1245596" indent="0">
              <a:buNone/>
              <a:defRPr sz="1362"/>
            </a:lvl5pPr>
            <a:lvl6pPr marL="1556995" indent="0">
              <a:buNone/>
              <a:defRPr sz="1362"/>
            </a:lvl6pPr>
            <a:lvl7pPr marL="1868394" indent="0">
              <a:buNone/>
              <a:defRPr sz="1362"/>
            </a:lvl7pPr>
            <a:lvl8pPr marL="2179792" indent="0">
              <a:buNone/>
              <a:defRPr sz="1362"/>
            </a:lvl8pPr>
            <a:lvl9pPr marL="2491191" indent="0">
              <a:buNone/>
              <a:defRPr sz="1362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970" y="2057400"/>
            <a:ext cx="2008616" cy="3811588"/>
          </a:xfrm>
        </p:spPr>
        <p:txBody>
          <a:bodyPr/>
          <a:lstStyle>
            <a:lvl1pPr marL="0" indent="0">
              <a:buNone/>
              <a:defRPr sz="1090"/>
            </a:lvl1pPr>
            <a:lvl2pPr marL="311399" indent="0">
              <a:buNone/>
              <a:defRPr sz="954"/>
            </a:lvl2pPr>
            <a:lvl3pPr marL="622798" indent="0">
              <a:buNone/>
              <a:defRPr sz="817"/>
            </a:lvl3pPr>
            <a:lvl4pPr marL="934197" indent="0">
              <a:buNone/>
              <a:defRPr sz="681"/>
            </a:lvl4pPr>
            <a:lvl5pPr marL="1245596" indent="0">
              <a:buNone/>
              <a:defRPr sz="681"/>
            </a:lvl5pPr>
            <a:lvl6pPr marL="1556995" indent="0">
              <a:buNone/>
              <a:defRPr sz="681"/>
            </a:lvl6pPr>
            <a:lvl7pPr marL="1868394" indent="0">
              <a:buNone/>
              <a:defRPr sz="681"/>
            </a:lvl7pPr>
            <a:lvl8pPr marL="2179792" indent="0">
              <a:buNone/>
              <a:defRPr sz="681"/>
            </a:lvl8pPr>
            <a:lvl9pPr marL="2491191" indent="0">
              <a:buNone/>
              <a:defRPr sz="6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5/5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677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8159" y="365127"/>
            <a:ext cx="5371446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159" y="1825625"/>
            <a:ext cx="5371446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8159" y="6356352"/>
            <a:ext cx="140124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13F134-369A-4EC9-9A1D-1D1677B45A0B}" type="datetimeFigureOut">
              <a:rPr kumimoji="1" lang="ja-JP" altLang="en-US" smtClean="0"/>
              <a:t>2025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62947" y="6356352"/>
            <a:ext cx="210187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8357" y="6356352"/>
            <a:ext cx="140124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5808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2798" rtl="0" eaLnBrk="1" latinLnBrk="0" hangingPunct="1">
        <a:lnSpc>
          <a:spcPct val="90000"/>
        </a:lnSpc>
        <a:spcBef>
          <a:spcPct val="0"/>
        </a:spcBef>
        <a:buNone/>
        <a:defRPr kumimoji="1" sz="29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699" indent="-155699" algn="l" defTabSz="622798" rtl="0" eaLnBrk="1" latinLnBrk="0" hangingPunct="1">
        <a:lnSpc>
          <a:spcPct val="90000"/>
        </a:lnSpc>
        <a:spcBef>
          <a:spcPts val="681"/>
        </a:spcBef>
        <a:buFont typeface="Arial" panose="020B0604020202020204" pitchFamily="34" charset="0"/>
        <a:buChar char="•"/>
        <a:defRPr kumimoji="1" sz="1907" kern="1200">
          <a:solidFill>
            <a:schemeClr val="tx1"/>
          </a:solidFill>
          <a:latin typeface="+mn-lt"/>
          <a:ea typeface="+mn-ea"/>
          <a:cs typeface="+mn-cs"/>
        </a:defRPr>
      </a:lvl1pPr>
      <a:lvl2pPr marL="467098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kumimoji="1" sz="1635" kern="1200">
          <a:solidFill>
            <a:schemeClr val="tx1"/>
          </a:solidFill>
          <a:latin typeface="+mn-lt"/>
          <a:ea typeface="+mn-ea"/>
          <a:cs typeface="+mn-cs"/>
        </a:defRPr>
      </a:lvl2pPr>
      <a:lvl3pPr marL="778497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kumimoji="1" sz="1362" kern="1200">
          <a:solidFill>
            <a:schemeClr val="tx1"/>
          </a:solidFill>
          <a:latin typeface="+mn-lt"/>
          <a:ea typeface="+mn-ea"/>
          <a:cs typeface="+mn-cs"/>
        </a:defRPr>
      </a:lvl3pPr>
      <a:lvl4pPr marL="1089896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4pPr>
      <a:lvl5pPr marL="1401295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5pPr>
      <a:lvl6pPr marL="1712694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6pPr>
      <a:lvl7pPr marL="2024093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7pPr>
      <a:lvl8pPr marL="2335492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8pPr>
      <a:lvl9pPr marL="2646891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1pPr>
      <a:lvl2pPr marL="311399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2pPr>
      <a:lvl3pPr marL="622798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3pPr>
      <a:lvl4pPr marL="934197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4pPr>
      <a:lvl5pPr marL="1245596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5pPr>
      <a:lvl6pPr marL="1556995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6pPr>
      <a:lvl7pPr marL="1868394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7pPr>
      <a:lvl8pPr marL="2179792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8pPr>
      <a:lvl9pPr marL="2491191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ACA0990-7BDA-6FE4-2BFD-7160C60E4BA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72BFF46-D68B-AE0E-2228-BDB9CD5EAA5C}"/>
              </a:ext>
            </a:extLst>
          </p:cNvPr>
          <p:cNvSpPr txBox="1"/>
          <p:nvPr/>
        </p:nvSpPr>
        <p:spPr>
          <a:xfrm>
            <a:off x="2088829" y="2308489"/>
            <a:ext cx="28725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32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18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5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1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0</a:t>
            </a:r>
            <a:endParaRPr kumimoji="1" lang="ja-JP" altLang="en-US" sz="8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13" name="図 12" descr="グラフ が含まれている画像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A19E6A08-EA61-7F9A-94C0-A6FEE195B2C6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68" t="9274" b="19798"/>
          <a:stretch/>
        </p:blipFill>
        <p:spPr>
          <a:xfrm>
            <a:off x="417566" y="231475"/>
            <a:ext cx="3096000" cy="1944000"/>
          </a:xfrm>
          <a:prstGeom prst="rect">
            <a:avLst/>
          </a:prstGeom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1A4202F-0E2D-33C9-7612-16327AC35787}"/>
              </a:ext>
            </a:extLst>
          </p:cNvPr>
          <p:cNvSpPr txBox="1"/>
          <p:nvPr/>
        </p:nvSpPr>
        <p:spPr>
          <a:xfrm>
            <a:off x="1758943" y="2310411"/>
            <a:ext cx="28725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36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22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6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3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0</a:t>
            </a:r>
            <a:endParaRPr kumimoji="1" lang="ja-JP" altLang="en-US" sz="8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9E224BD-452C-BF89-3249-DD2F27FC9514}"/>
              </a:ext>
            </a:extLst>
          </p:cNvPr>
          <p:cNvSpPr txBox="1"/>
          <p:nvPr/>
        </p:nvSpPr>
        <p:spPr>
          <a:xfrm rot="16200000">
            <a:off x="-542270" y="1097028"/>
            <a:ext cx="13660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A recurrence free survival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D8D94E1-8187-485B-AC1F-B111B4561B24}"/>
              </a:ext>
            </a:extLst>
          </p:cNvPr>
          <p:cNvSpPr txBox="1"/>
          <p:nvPr/>
        </p:nvSpPr>
        <p:spPr>
          <a:xfrm>
            <a:off x="1251453" y="2195526"/>
            <a:ext cx="13003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rgery (month)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BCF9DF4-343B-7DC4-E375-BC0ABA79605B}"/>
              </a:ext>
            </a:extLst>
          </p:cNvPr>
          <p:cNvSpPr txBox="1"/>
          <p:nvPr/>
        </p:nvSpPr>
        <p:spPr>
          <a:xfrm>
            <a:off x="770588" y="1728852"/>
            <a:ext cx="10903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P &lt;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01*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index = 0.827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E325283-1FEB-C872-5E1C-4F54076163DB}"/>
              </a:ext>
            </a:extLst>
          </p:cNvPr>
          <p:cNvSpPr txBox="1"/>
          <p:nvPr/>
        </p:nvSpPr>
        <p:spPr>
          <a:xfrm>
            <a:off x="0" y="0"/>
            <a:ext cx="33618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1" lang="en-US" altLang="ja-JP" sz="8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1   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curves according to the total point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2B44A9E-1D16-267A-ED4C-0D4D18A1E592}"/>
              </a:ext>
            </a:extLst>
          </p:cNvPr>
          <p:cNvSpPr txBox="1"/>
          <p:nvPr/>
        </p:nvSpPr>
        <p:spPr>
          <a:xfrm>
            <a:off x="431690" y="2104779"/>
            <a:ext cx="2752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B32F62A-91A1-5DAC-917C-8582376379D9}"/>
              </a:ext>
            </a:extLst>
          </p:cNvPr>
          <p:cNvSpPr txBox="1"/>
          <p:nvPr/>
        </p:nvSpPr>
        <p:spPr>
          <a:xfrm>
            <a:off x="-50531" y="2200530"/>
            <a:ext cx="7986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F1B9706-540E-51C0-63CE-B8CAD8FD7327}"/>
              </a:ext>
            </a:extLst>
          </p:cNvPr>
          <p:cNvSpPr txBox="1"/>
          <p:nvPr/>
        </p:nvSpPr>
        <p:spPr>
          <a:xfrm>
            <a:off x="2623559" y="426375"/>
            <a:ext cx="513282" cy="6694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868"/>
              </a:lnSpc>
            </a:pP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point</a:t>
            </a:r>
          </a:p>
          <a:p>
            <a:pPr>
              <a:lnSpc>
                <a:spcPts val="868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point</a:t>
            </a:r>
          </a:p>
          <a:p>
            <a:pPr>
              <a:lnSpc>
                <a:spcPts val="868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points</a:t>
            </a:r>
          </a:p>
          <a:p>
            <a:pPr>
              <a:lnSpc>
                <a:spcPts val="868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points</a:t>
            </a:r>
          </a:p>
          <a:p>
            <a:pPr>
              <a:lnSpc>
                <a:spcPts val="868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point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8013D73B-366E-ED52-76B1-407F296C30AE}"/>
              </a:ext>
            </a:extLst>
          </p:cNvPr>
          <p:cNvSpPr/>
          <p:nvPr/>
        </p:nvSpPr>
        <p:spPr>
          <a:xfrm>
            <a:off x="2583281" y="641392"/>
            <a:ext cx="108000" cy="18000"/>
          </a:xfrm>
          <a:prstGeom prst="rect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 dirty="0"/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0B2CA5F2-7777-FB4E-2C1A-29C21E713311}"/>
              </a:ext>
            </a:extLst>
          </p:cNvPr>
          <p:cNvSpPr/>
          <p:nvPr/>
        </p:nvSpPr>
        <p:spPr>
          <a:xfrm>
            <a:off x="2584938" y="866805"/>
            <a:ext cx="108000" cy="18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/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498D9A5A-E597-AEDD-1E7E-E07E5A09B223}"/>
              </a:ext>
            </a:extLst>
          </p:cNvPr>
          <p:cNvSpPr/>
          <p:nvPr/>
        </p:nvSpPr>
        <p:spPr>
          <a:xfrm>
            <a:off x="2583281" y="986542"/>
            <a:ext cx="108000" cy="1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A738AAD4-793B-FACF-AA1B-B088B0EC4D51}"/>
              </a:ext>
            </a:extLst>
          </p:cNvPr>
          <p:cNvSpPr txBox="1"/>
          <p:nvPr/>
        </p:nvSpPr>
        <p:spPr>
          <a:xfrm>
            <a:off x="749589" y="2106714"/>
            <a:ext cx="3098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D3BE2DBE-9DED-E610-F2B6-6DB221410746}"/>
              </a:ext>
            </a:extLst>
          </p:cNvPr>
          <p:cNvSpPr txBox="1"/>
          <p:nvPr/>
        </p:nvSpPr>
        <p:spPr>
          <a:xfrm>
            <a:off x="1087121" y="2107704"/>
            <a:ext cx="3026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E50365E0-7F6A-D5C0-6BBC-7B9F7B27D427}"/>
              </a:ext>
            </a:extLst>
          </p:cNvPr>
          <p:cNvSpPr txBox="1"/>
          <p:nvPr/>
        </p:nvSpPr>
        <p:spPr>
          <a:xfrm>
            <a:off x="1409911" y="2107817"/>
            <a:ext cx="3216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757F3141-7F75-9557-FE85-2836AF2FD54D}"/>
              </a:ext>
            </a:extLst>
          </p:cNvPr>
          <p:cNvSpPr txBox="1"/>
          <p:nvPr/>
        </p:nvSpPr>
        <p:spPr>
          <a:xfrm>
            <a:off x="1755997" y="2108068"/>
            <a:ext cx="3002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4D7B0C2F-46EF-1961-910E-2DE41CDCEEF7}"/>
              </a:ext>
            </a:extLst>
          </p:cNvPr>
          <p:cNvSpPr txBox="1"/>
          <p:nvPr/>
        </p:nvSpPr>
        <p:spPr>
          <a:xfrm>
            <a:off x="2084152" y="2107704"/>
            <a:ext cx="3080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1030EF5D-F148-C1CC-9EF6-1DFE03DF7C35}"/>
              </a:ext>
            </a:extLst>
          </p:cNvPr>
          <p:cNvSpPr txBox="1"/>
          <p:nvPr/>
        </p:nvSpPr>
        <p:spPr>
          <a:xfrm>
            <a:off x="2409179" y="2109865"/>
            <a:ext cx="32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673DFDE3-A973-C23B-3FB9-92313AE7747F}"/>
              </a:ext>
            </a:extLst>
          </p:cNvPr>
          <p:cNvSpPr txBox="1"/>
          <p:nvPr/>
        </p:nvSpPr>
        <p:spPr>
          <a:xfrm>
            <a:off x="2739702" y="2104040"/>
            <a:ext cx="330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4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9E444EB-112F-6BF9-B375-CEC8324DFEAA}"/>
              </a:ext>
            </a:extLst>
          </p:cNvPr>
          <p:cNvSpPr txBox="1"/>
          <p:nvPr/>
        </p:nvSpPr>
        <p:spPr>
          <a:xfrm>
            <a:off x="3060839" y="2106714"/>
            <a:ext cx="3592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6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91518FE5-428C-7F8C-B59A-3B048C0D8ABA}"/>
              </a:ext>
            </a:extLst>
          </p:cNvPr>
          <p:cNvSpPr txBox="1"/>
          <p:nvPr/>
        </p:nvSpPr>
        <p:spPr>
          <a:xfrm>
            <a:off x="-52430" y="2307851"/>
            <a:ext cx="51328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point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point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points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points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points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A7FFEC79-F972-4F85-DC8A-5247B31B8083}"/>
              </a:ext>
            </a:extLst>
          </p:cNvPr>
          <p:cNvSpPr txBox="1"/>
          <p:nvPr/>
        </p:nvSpPr>
        <p:spPr>
          <a:xfrm>
            <a:off x="423753" y="2311114"/>
            <a:ext cx="287258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40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37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18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16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3</a:t>
            </a:r>
            <a:endParaRPr kumimoji="1" lang="ja-JP" altLang="en-US" sz="8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2717C348-174E-1BA2-141B-6EB4B3245BF2}"/>
              </a:ext>
            </a:extLst>
          </p:cNvPr>
          <p:cNvSpPr txBox="1"/>
          <p:nvPr/>
        </p:nvSpPr>
        <p:spPr>
          <a:xfrm>
            <a:off x="756166" y="2311114"/>
            <a:ext cx="28725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38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33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14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7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0</a:t>
            </a:r>
            <a:endParaRPr kumimoji="1" lang="ja-JP" altLang="en-US" sz="8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25EBDA5C-5918-ED7A-CB68-89D9B6C0AE73}"/>
              </a:ext>
            </a:extLst>
          </p:cNvPr>
          <p:cNvSpPr/>
          <p:nvPr/>
        </p:nvSpPr>
        <p:spPr>
          <a:xfrm>
            <a:off x="2583281" y="528074"/>
            <a:ext cx="108000" cy="18000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 dirty="0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48DDAAC4-4D01-FFAA-3EC8-AC2F88A8F01E}"/>
              </a:ext>
            </a:extLst>
          </p:cNvPr>
          <p:cNvSpPr/>
          <p:nvPr/>
        </p:nvSpPr>
        <p:spPr>
          <a:xfrm>
            <a:off x="2583281" y="752129"/>
            <a:ext cx="108000" cy="18000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5E9C60E-A0C3-3896-E075-6CC9AB8AABD2}"/>
              </a:ext>
            </a:extLst>
          </p:cNvPr>
          <p:cNvSpPr txBox="1"/>
          <p:nvPr/>
        </p:nvSpPr>
        <p:spPr>
          <a:xfrm>
            <a:off x="1092776" y="2311797"/>
            <a:ext cx="28725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37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29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8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4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0</a:t>
            </a:r>
            <a:endParaRPr kumimoji="1" lang="ja-JP" altLang="en-US" sz="8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3BCCC3E-B22A-B13E-9D19-8D04E5022720}"/>
              </a:ext>
            </a:extLst>
          </p:cNvPr>
          <p:cNvSpPr txBox="1"/>
          <p:nvPr/>
        </p:nvSpPr>
        <p:spPr>
          <a:xfrm>
            <a:off x="1423168" y="2310411"/>
            <a:ext cx="28725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37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26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6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4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0</a:t>
            </a:r>
            <a:endParaRPr kumimoji="1" lang="ja-JP" altLang="en-US" sz="8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A099BE87-66F8-2366-D01D-76E4CE8E9DEF}"/>
              </a:ext>
            </a:extLst>
          </p:cNvPr>
          <p:cNvSpPr txBox="1"/>
          <p:nvPr/>
        </p:nvSpPr>
        <p:spPr>
          <a:xfrm>
            <a:off x="2425563" y="2307851"/>
            <a:ext cx="28725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11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6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1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1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0</a:t>
            </a:r>
            <a:endParaRPr kumimoji="1" lang="ja-JP" altLang="en-US" sz="8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5916DF1-C25A-1254-E3F6-9B5340375418}"/>
              </a:ext>
            </a:extLst>
          </p:cNvPr>
          <p:cNvSpPr txBox="1"/>
          <p:nvPr/>
        </p:nvSpPr>
        <p:spPr>
          <a:xfrm>
            <a:off x="2780262" y="2307851"/>
            <a:ext cx="23596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3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1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1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1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0</a:t>
            </a:r>
            <a:endParaRPr kumimoji="1" lang="ja-JP" altLang="en-US" sz="8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614D95F-8EEC-877D-C8C8-02F155A5263D}"/>
              </a:ext>
            </a:extLst>
          </p:cNvPr>
          <p:cNvSpPr txBox="1"/>
          <p:nvPr/>
        </p:nvSpPr>
        <p:spPr>
          <a:xfrm>
            <a:off x="3116872" y="2305291"/>
            <a:ext cx="23596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0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0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0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0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0</a:t>
            </a:r>
            <a:endParaRPr kumimoji="1" lang="ja-JP" altLang="en-US" sz="8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EC0B76F-6E4C-5595-B538-BDEB1669752E}"/>
              </a:ext>
            </a:extLst>
          </p:cNvPr>
          <p:cNvSpPr txBox="1"/>
          <p:nvPr/>
        </p:nvSpPr>
        <p:spPr>
          <a:xfrm>
            <a:off x="112996" y="171488"/>
            <a:ext cx="407904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0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0C4712F-1E48-3FF8-EBF0-BB8CAB3CDD1B}"/>
              </a:ext>
            </a:extLst>
          </p:cNvPr>
          <p:cNvSpPr txBox="1"/>
          <p:nvPr/>
        </p:nvSpPr>
        <p:spPr>
          <a:xfrm>
            <a:off x="114687" y="606859"/>
            <a:ext cx="407904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5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1400891-1D9D-57D0-C1E4-08F21DDADCD2}"/>
              </a:ext>
            </a:extLst>
          </p:cNvPr>
          <p:cNvSpPr txBox="1"/>
          <p:nvPr/>
        </p:nvSpPr>
        <p:spPr>
          <a:xfrm>
            <a:off x="112989" y="1049318"/>
            <a:ext cx="407904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0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F330269-B64C-2499-7D26-C5FBA5292F68}"/>
              </a:ext>
            </a:extLst>
          </p:cNvPr>
          <p:cNvSpPr txBox="1"/>
          <p:nvPr/>
        </p:nvSpPr>
        <p:spPr>
          <a:xfrm>
            <a:off x="112995" y="1485231"/>
            <a:ext cx="407904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5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0F5CED5-5023-A9AE-1454-0624890F7321}"/>
              </a:ext>
            </a:extLst>
          </p:cNvPr>
          <p:cNvSpPr txBox="1"/>
          <p:nvPr/>
        </p:nvSpPr>
        <p:spPr>
          <a:xfrm>
            <a:off x="112995" y="1925623"/>
            <a:ext cx="407904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</a:t>
            </a:r>
          </a:p>
        </p:txBody>
      </p:sp>
    </p:spTree>
    <p:extLst>
      <p:ext uri="{BB962C8B-B14F-4D97-AF65-F5344CB8AC3E}">
        <p14:creationId xmlns:p14="http://schemas.microsoft.com/office/powerpoint/2010/main" val="27053132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069C4811-C185-A719-27BC-DF39EAEDC76C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2350" t="15513" r="5722" b="16696"/>
          <a:stretch/>
        </p:blipFill>
        <p:spPr>
          <a:xfrm>
            <a:off x="4270557" y="321964"/>
            <a:ext cx="1949843" cy="14760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2A16AFAB-BFAF-0991-1839-07D844B65BA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4376"/>
          <a:stretch/>
        </p:blipFill>
        <p:spPr>
          <a:xfrm>
            <a:off x="1478353" y="91084"/>
            <a:ext cx="2700693" cy="2160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E0CD572-8571-19D9-D754-49A0068F2F2B}"/>
              </a:ext>
            </a:extLst>
          </p:cNvPr>
          <p:cNvSpPr txBox="1"/>
          <p:nvPr/>
        </p:nvSpPr>
        <p:spPr>
          <a:xfrm>
            <a:off x="0" y="0"/>
            <a:ext cx="44791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  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mogram and calibration plot for predicting 3-year recurrence-free survival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AutoShape 2">
            <a:extLst>
              <a:ext uri="{FF2B5EF4-FFF2-40B4-BE49-F238E27FC236}">
                <a16:creationId xmlns:a16="http://schemas.microsoft.com/office/drawing/2014/main" id="{19564159-ED57-7AD7-0439-79207F1769D3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82803" y="798715"/>
            <a:ext cx="2782685" cy="27826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16225DE-9F43-8575-1FB4-134FCCB0AD0D}"/>
              </a:ext>
            </a:extLst>
          </p:cNvPr>
          <p:cNvSpPr txBox="1"/>
          <p:nvPr/>
        </p:nvSpPr>
        <p:spPr>
          <a:xfrm>
            <a:off x="0" y="293966"/>
            <a:ext cx="1436612" cy="1692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ints</a:t>
            </a:r>
          </a:p>
          <a:p>
            <a:endParaRPr lang="en-US" altLang="ja-JP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UP grade group at SM</a:t>
            </a:r>
          </a:p>
          <a:p>
            <a:endParaRPr lang="en-US" altLang="ja-JP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dir PSA</a:t>
            </a:r>
          </a:p>
          <a:p>
            <a:endParaRPr lang="en-US" altLang="ja-JP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x. length of cancer</a:t>
            </a:r>
            <a:r>
              <a: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</a:t>
            </a:r>
          </a:p>
          <a:p>
            <a:endParaRPr lang="en-US" altLang="ja-JP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points</a:t>
            </a:r>
          </a:p>
          <a:p>
            <a:endParaRPr lang="en-US" altLang="ja-JP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ar predictor</a:t>
            </a:r>
          </a:p>
          <a:p>
            <a:endParaRPr lang="en-US" altLang="ja-JP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-year recurrence free survival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BEC2C17-A437-E2E4-9EB0-65F5AE397DA5}"/>
              </a:ext>
            </a:extLst>
          </p:cNvPr>
          <p:cNvSpPr txBox="1"/>
          <p:nvPr/>
        </p:nvSpPr>
        <p:spPr>
          <a:xfrm>
            <a:off x="1737844" y="566124"/>
            <a:ext cx="171054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F789040-0DB6-1DD6-FAE3-E71F0E149F15}"/>
              </a:ext>
            </a:extLst>
          </p:cNvPr>
          <p:cNvSpPr txBox="1"/>
          <p:nvPr/>
        </p:nvSpPr>
        <p:spPr>
          <a:xfrm>
            <a:off x="1913077" y="703239"/>
            <a:ext cx="227160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- 5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73110D2-FF63-FAB6-BC22-18C320082927}"/>
              </a:ext>
            </a:extLst>
          </p:cNvPr>
          <p:cNvSpPr txBox="1"/>
          <p:nvPr/>
        </p:nvSpPr>
        <p:spPr>
          <a:xfrm>
            <a:off x="1499000" y="697899"/>
            <a:ext cx="214336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-2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DAB7AF2-C16E-F527-E250-3FB22B452884}"/>
              </a:ext>
            </a:extLst>
          </p:cNvPr>
          <p:cNvSpPr txBox="1"/>
          <p:nvPr/>
        </p:nvSpPr>
        <p:spPr>
          <a:xfrm>
            <a:off x="1520641" y="334777"/>
            <a:ext cx="171054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5B96E5F-AE06-119D-C9FB-21C814483076}"/>
              </a:ext>
            </a:extLst>
          </p:cNvPr>
          <p:cNvSpPr txBox="1"/>
          <p:nvPr/>
        </p:nvSpPr>
        <p:spPr>
          <a:xfrm>
            <a:off x="1744472" y="335156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4C585A3-2CBC-0D5A-4D4B-A26A52F6A03B}"/>
              </a:ext>
            </a:extLst>
          </p:cNvPr>
          <p:cNvSpPr txBox="1"/>
          <p:nvPr/>
        </p:nvSpPr>
        <p:spPr>
          <a:xfrm>
            <a:off x="1973980" y="334777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F065E87-9213-5E0F-6FE3-2566AD0E2C52}"/>
              </a:ext>
            </a:extLst>
          </p:cNvPr>
          <p:cNvSpPr txBox="1"/>
          <p:nvPr/>
        </p:nvSpPr>
        <p:spPr>
          <a:xfrm>
            <a:off x="2203488" y="334776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8F5B854-278F-1A29-F386-39377E6E58B3}"/>
              </a:ext>
            </a:extLst>
          </p:cNvPr>
          <p:cNvSpPr txBox="1"/>
          <p:nvPr/>
        </p:nvSpPr>
        <p:spPr>
          <a:xfrm>
            <a:off x="2432996" y="334776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0405378-75AB-DABD-F267-1C88A448E830}"/>
              </a:ext>
            </a:extLst>
          </p:cNvPr>
          <p:cNvSpPr txBox="1"/>
          <p:nvPr/>
        </p:nvSpPr>
        <p:spPr>
          <a:xfrm>
            <a:off x="2662504" y="334776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92132BC-B2FC-A0E9-CADC-D740420262E4}"/>
              </a:ext>
            </a:extLst>
          </p:cNvPr>
          <p:cNvSpPr txBox="1"/>
          <p:nvPr/>
        </p:nvSpPr>
        <p:spPr>
          <a:xfrm>
            <a:off x="2892012" y="334776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51B257C-72E1-F97A-BC33-F4E5108494EE}"/>
              </a:ext>
            </a:extLst>
          </p:cNvPr>
          <p:cNvSpPr txBox="1"/>
          <p:nvPr/>
        </p:nvSpPr>
        <p:spPr>
          <a:xfrm>
            <a:off x="3121099" y="334776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47156B7-48C7-35E3-A9EC-C023FA8F63F6}"/>
              </a:ext>
            </a:extLst>
          </p:cNvPr>
          <p:cNvSpPr txBox="1"/>
          <p:nvPr/>
        </p:nvSpPr>
        <p:spPr>
          <a:xfrm>
            <a:off x="3350186" y="334775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C035596-5561-AFE6-B68F-0B3660B5869B}"/>
              </a:ext>
            </a:extLst>
          </p:cNvPr>
          <p:cNvSpPr txBox="1"/>
          <p:nvPr/>
        </p:nvSpPr>
        <p:spPr>
          <a:xfrm>
            <a:off x="3582822" y="334775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17FE1CA-2F20-EA25-BC2A-ADAE6E996FD5}"/>
              </a:ext>
            </a:extLst>
          </p:cNvPr>
          <p:cNvSpPr txBox="1"/>
          <p:nvPr/>
        </p:nvSpPr>
        <p:spPr>
          <a:xfrm>
            <a:off x="3800764" y="334774"/>
            <a:ext cx="222351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AEAD577-AD90-53C3-41E5-0C68B1C8EB47}"/>
              </a:ext>
            </a:extLst>
          </p:cNvPr>
          <p:cNvSpPr txBox="1"/>
          <p:nvPr/>
        </p:nvSpPr>
        <p:spPr>
          <a:xfrm>
            <a:off x="1492191" y="930490"/>
            <a:ext cx="235175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4D62E1AB-89E0-4F99-595A-3F324CB8FF8A}"/>
              </a:ext>
            </a:extLst>
          </p:cNvPr>
          <p:cNvSpPr txBox="1"/>
          <p:nvPr/>
        </p:nvSpPr>
        <p:spPr>
          <a:xfrm>
            <a:off x="2664029" y="929836"/>
            <a:ext cx="276854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ja-JP" altLang="en-US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 </a:t>
            </a:r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3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FAE9ADA-E532-AB84-1BD0-C2262F83DF3C}"/>
              </a:ext>
            </a:extLst>
          </p:cNvPr>
          <p:cNvSpPr txBox="1"/>
          <p:nvPr/>
        </p:nvSpPr>
        <p:spPr>
          <a:xfrm>
            <a:off x="2089138" y="809576"/>
            <a:ext cx="235175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2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E75ACAD-C553-1BB1-9B58-24763820D867}"/>
              </a:ext>
            </a:extLst>
          </p:cNvPr>
          <p:cNvSpPr txBox="1"/>
          <p:nvPr/>
        </p:nvSpPr>
        <p:spPr>
          <a:xfrm>
            <a:off x="1525915" y="1159544"/>
            <a:ext cx="171054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5DB4F7F-ACAF-7F22-1F76-7291D51065EF}"/>
              </a:ext>
            </a:extLst>
          </p:cNvPr>
          <p:cNvSpPr txBox="1"/>
          <p:nvPr/>
        </p:nvSpPr>
        <p:spPr>
          <a:xfrm>
            <a:off x="1855431" y="1159543"/>
            <a:ext cx="171054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03D9FED-50B3-EB48-D289-CB723BCF57CC}"/>
              </a:ext>
            </a:extLst>
          </p:cNvPr>
          <p:cNvSpPr txBox="1"/>
          <p:nvPr/>
        </p:nvSpPr>
        <p:spPr>
          <a:xfrm>
            <a:off x="2169354" y="1159543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3338059-A57D-1E8F-C5F3-04F645F7C52B}"/>
              </a:ext>
            </a:extLst>
          </p:cNvPr>
          <p:cNvSpPr txBox="1"/>
          <p:nvPr/>
        </p:nvSpPr>
        <p:spPr>
          <a:xfrm>
            <a:off x="2498508" y="1159543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37FC487-7AFD-C5C0-AE65-01A55F76DE3C}"/>
              </a:ext>
            </a:extLst>
          </p:cNvPr>
          <p:cNvSpPr txBox="1"/>
          <p:nvPr/>
        </p:nvSpPr>
        <p:spPr>
          <a:xfrm>
            <a:off x="2825121" y="1159542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511CAB3-048A-32DC-D4CF-E4B1173A351E}"/>
              </a:ext>
            </a:extLst>
          </p:cNvPr>
          <p:cNvSpPr txBox="1"/>
          <p:nvPr/>
        </p:nvSpPr>
        <p:spPr>
          <a:xfrm>
            <a:off x="3157686" y="1159542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125DC44B-414A-3EE2-F156-4FD7BADAD7E9}"/>
              </a:ext>
            </a:extLst>
          </p:cNvPr>
          <p:cNvSpPr txBox="1"/>
          <p:nvPr/>
        </p:nvSpPr>
        <p:spPr>
          <a:xfrm>
            <a:off x="3484785" y="1159541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E4CB5B29-8097-99EB-A678-1F0C5831BF5A}"/>
              </a:ext>
            </a:extLst>
          </p:cNvPr>
          <p:cNvSpPr txBox="1"/>
          <p:nvPr/>
        </p:nvSpPr>
        <p:spPr>
          <a:xfrm>
            <a:off x="3811968" y="1159541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CBBED98A-18C7-0A60-83B5-D496522C9190}"/>
              </a:ext>
            </a:extLst>
          </p:cNvPr>
          <p:cNvSpPr txBox="1"/>
          <p:nvPr/>
        </p:nvSpPr>
        <p:spPr>
          <a:xfrm>
            <a:off x="1525453" y="1398983"/>
            <a:ext cx="171054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7B7A3A0-0E59-07A7-23A5-EFDA0CB45E91}"/>
              </a:ext>
            </a:extLst>
          </p:cNvPr>
          <p:cNvSpPr txBox="1"/>
          <p:nvPr/>
        </p:nvSpPr>
        <p:spPr>
          <a:xfrm>
            <a:off x="1693939" y="1399362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3AAB79A9-F20B-C212-B278-4272A42342D8}"/>
              </a:ext>
            </a:extLst>
          </p:cNvPr>
          <p:cNvSpPr txBox="1"/>
          <p:nvPr/>
        </p:nvSpPr>
        <p:spPr>
          <a:xfrm>
            <a:off x="1865695" y="1398983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6A8989F-9BFF-7605-56C7-3B43298C2E99}"/>
              </a:ext>
            </a:extLst>
          </p:cNvPr>
          <p:cNvSpPr txBox="1"/>
          <p:nvPr/>
        </p:nvSpPr>
        <p:spPr>
          <a:xfrm>
            <a:off x="2044671" y="1398982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8C681FE1-3C81-A4E6-CDBA-EC802D547703}"/>
              </a:ext>
            </a:extLst>
          </p:cNvPr>
          <p:cNvSpPr txBox="1"/>
          <p:nvPr/>
        </p:nvSpPr>
        <p:spPr>
          <a:xfrm>
            <a:off x="2223649" y="1398982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9F04D3B-9F00-BA4F-E88F-6EA1AEC7B82C}"/>
              </a:ext>
            </a:extLst>
          </p:cNvPr>
          <p:cNvSpPr txBox="1"/>
          <p:nvPr/>
        </p:nvSpPr>
        <p:spPr>
          <a:xfrm>
            <a:off x="2397808" y="1398982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96FAECB8-474A-499B-F1E5-044451165082}"/>
              </a:ext>
            </a:extLst>
          </p:cNvPr>
          <p:cNvSpPr txBox="1"/>
          <p:nvPr/>
        </p:nvSpPr>
        <p:spPr>
          <a:xfrm>
            <a:off x="2576784" y="1398982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96F3B5FF-C05E-5709-91C6-50F788E9F428}"/>
              </a:ext>
            </a:extLst>
          </p:cNvPr>
          <p:cNvSpPr txBox="1"/>
          <p:nvPr/>
        </p:nvSpPr>
        <p:spPr>
          <a:xfrm>
            <a:off x="2750523" y="1398982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A0560917-0820-9F68-0546-A52F20A871AC}"/>
              </a:ext>
            </a:extLst>
          </p:cNvPr>
          <p:cNvSpPr txBox="1"/>
          <p:nvPr/>
        </p:nvSpPr>
        <p:spPr>
          <a:xfrm>
            <a:off x="2924264" y="1398981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48EBD66B-8B01-505A-85A6-A62CC4DD32DE}"/>
              </a:ext>
            </a:extLst>
          </p:cNvPr>
          <p:cNvSpPr txBox="1"/>
          <p:nvPr/>
        </p:nvSpPr>
        <p:spPr>
          <a:xfrm>
            <a:off x="3106374" y="1398981"/>
            <a:ext cx="196703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0E90D8C8-9E4B-E512-FC53-8A1ADF8FBF51}"/>
              </a:ext>
            </a:extLst>
          </p:cNvPr>
          <p:cNvSpPr txBox="1"/>
          <p:nvPr/>
        </p:nvSpPr>
        <p:spPr>
          <a:xfrm>
            <a:off x="3268972" y="1398980"/>
            <a:ext cx="222351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EE1B8EF3-F7CF-67DB-41F3-2F548DA3067A}"/>
              </a:ext>
            </a:extLst>
          </p:cNvPr>
          <p:cNvSpPr txBox="1"/>
          <p:nvPr/>
        </p:nvSpPr>
        <p:spPr>
          <a:xfrm>
            <a:off x="3447236" y="1398980"/>
            <a:ext cx="222351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F0FFFE28-F1AA-FD70-424C-6F7ABA730C88}"/>
              </a:ext>
            </a:extLst>
          </p:cNvPr>
          <p:cNvSpPr txBox="1"/>
          <p:nvPr/>
        </p:nvSpPr>
        <p:spPr>
          <a:xfrm>
            <a:off x="3624534" y="1398980"/>
            <a:ext cx="222351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DDEAD8E-357E-62AD-E831-ECFFD3861333}"/>
              </a:ext>
            </a:extLst>
          </p:cNvPr>
          <p:cNvSpPr txBox="1"/>
          <p:nvPr/>
        </p:nvSpPr>
        <p:spPr>
          <a:xfrm>
            <a:off x="3799956" y="1398979"/>
            <a:ext cx="222351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85AC40A1-5795-1CFE-8587-6DE0D12F9C6F}"/>
              </a:ext>
            </a:extLst>
          </p:cNvPr>
          <p:cNvSpPr txBox="1"/>
          <p:nvPr/>
        </p:nvSpPr>
        <p:spPr>
          <a:xfrm>
            <a:off x="1419143" y="1641997"/>
            <a:ext cx="239984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2.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D4E38689-D68B-211E-1D98-9CF09A34D111}"/>
              </a:ext>
            </a:extLst>
          </p:cNvPr>
          <p:cNvSpPr txBox="1"/>
          <p:nvPr/>
        </p:nvSpPr>
        <p:spPr>
          <a:xfrm>
            <a:off x="1606686" y="1641996"/>
            <a:ext cx="239984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1.5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C4993223-2963-3343-E022-DFA21A7C1814}"/>
              </a:ext>
            </a:extLst>
          </p:cNvPr>
          <p:cNvSpPr txBox="1"/>
          <p:nvPr/>
        </p:nvSpPr>
        <p:spPr>
          <a:xfrm>
            <a:off x="1800277" y="1641996"/>
            <a:ext cx="227160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.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CF9DB69A-E3AE-FD46-2215-CA2B6D3B9C5F}"/>
              </a:ext>
            </a:extLst>
          </p:cNvPr>
          <p:cNvSpPr txBox="1"/>
          <p:nvPr/>
        </p:nvSpPr>
        <p:spPr>
          <a:xfrm>
            <a:off x="1981047" y="1641996"/>
            <a:ext cx="239984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0.5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935FFFEE-13F6-210D-9F94-109E0830BB21}"/>
              </a:ext>
            </a:extLst>
          </p:cNvPr>
          <p:cNvSpPr txBox="1"/>
          <p:nvPr/>
        </p:nvSpPr>
        <p:spPr>
          <a:xfrm>
            <a:off x="2185732" y="1641995"/>
            <a:ext cx="209527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CC20FE3D-68CA-5A57-6BE9-7649F6D6D508}"/>
              </a:ext>
            </a:extLst>
          </p:cNvPr>
          <p:cNvSpPr txBox="1"/>
          <p:nvPr/>
        </p:nvSpPr>
        <p:spPr>
          <a:xfrm>
            <a:off x="2376325" y="1641995"/>
            <a:ext cx="209527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7BEB870E-6A0D-144E-E211-A0A005544C12}"/>
              </a:ext>
            </a:extLst>
          </p:cNvPr>
          <p:cNvSpPr txBox="1"/>
          <p:nvPr/>
        </p:nvSpPr>
        <p:spPr>
          <a:xfrm>
            <a:off x="2563858" y="1641994"/>
            <a:ext cx="209527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529002BE-D8F6-87F7-6A54-0531D12BBAB4}"/>
              </a:ext>
            </a:extLst>
          </p:cNvPr>
          <p:cNvSpPr txBox="1"/>
          <p:nvPr/>
        </p:nvSpPr>
        <p:spPr>
          <a:xfrm>
            <a:off x="2753884" y="1641994"/>
            <a:ext cx="209527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23EA98BC-42E5-3B79-6C25-72FF0A2EC560}"/>
              </a:ext>
            </a:extLst>
          </p:cNvPr>
          <p:cNvSpPr txBox="1"/>
          <p:nvPr/>
        </p:nvSpPr>
        <p:spPr>
          <a:xfrm>
            <a:off x="2939499" y="1641970"/>
            <a:ext cx="209527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8528A8C6-ED63-3DA2-D82C-91E2127411DC}"/>
              </a:ext>
            </a:extLst>
          </p:cNvPr>
          <p:cNvSpPr txBox="1"/>
          <p:nvPr/>
        </p:nvSpPr>
        <p:spPr>
          <a:xfrm>
            <a:off x="3126549" y="1641969"/>
            <a:ext cx="209527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45030156-D21E-4755-5484-B051857A1644}"/>
              </a:ext>
            </a:extLst>
          </p:cNvPr>
          <p:cNvSpPr txBox="1"/>
          <p:nvPr/>
        </p:nvSpPr>
        <p:spPr>
          <a:xfrm>
            <a:off x="3317142" y="1641969"/>
            <a:ext cx="209527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BA4A25AA-BEE6-ABA7-1232-8B7BAC589245}"/>
              </a:ext>
            </a:extLst>
          </p:cNvPr>
          <p:cNvSpPr txBox="1"/>
          <p:nvPr/>
        </p:nvSpPr>
        <p:spPr>
          <a:xfrm>
            <a:off x="3504675" y="1641968"/>
            <a:ext cx="209527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5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C47F7362-5EC3-B5A0-518C-1CCD702AAED1}"/>
              </a:ext>
            </a:extLst>
          </p:cNvPr>
          <p:cNvSpPr txBox="1"/>
          <p:nvPr/>
        </p:nvSpPr>
        <p:spPr>
          <a:xfrm>
            <a:off x="3694701" y="1641968"/>
            <a:ext cx="209527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0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19F1DA9B-DEC9-BF8B-7D70-7F15109B6C6A}"/>
              </a:ext>
            </a:extLst>
          </p:cNvPr>
          <p:cNvSpPr txBox="1"/>
          <p:nvPr/>
        </p:nvSpPr>
        <p:spPr>
          <a:xfrm>
            <a:off x="1867963" y="1873783"/>
            <a:ext cx="209527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9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4AB2693F-695A-1DF6-B542-CC942C540951}"/>
              </a:ext>
            </a:extLst>
          </p:cNvPr>
          <p:cNvSpPr txBox="1"/>
          <p:nvPr/>
        </p:nvSpPr>
        <p:spPr>
          <a:xfrm>
            <a:off x="2148994" y="1873783"/>
            <a:ext cx="209527" cy="61555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58FD1028-96CD-0641-BA4F-480AAAAFBB9D}"/>
              </a:ext>
            </a:extLst>
          </p:cNvPr>
          <p:cNvSpPr txBox="1"/>
          <p:nvPr/>
        </p:nvSpPr>
        <p:spPr>
          <a:xfrm>
            <a:off x="2362765" y="1873782"/>
            <a:ext cx="136823" cy="61555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87761DC5-6AE9-4A83-0956-229637E1589A}"/>
              </a:ext>
            </a:extLst>
          </p:cNvPr>
          <p:cNvSpPr txBox="1"/>
          <p:nvPr/>
        </p:nvSpPr>
        <p:spPr>
          <a:xfrm>
            <a:off x="2503832" y="1873782"/>
            <a:ext cx="136823" cy="61555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A2C8DF0F-8A97-85FF-E094-B66BF0CD5065}"/>
              </a:ext>
            </a:extLst>
          </p:cNvPr>
          <p:cNvSpPr txBox="1"/>
          <p:nvPr/>
        </p:nvSpPr>
        <p:spPr>
          <a:xfrm>
            <a:off x="2613700" y="1873782"/>
            <a:ext cx="136823" cy="61555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D360DF6E-B174-F393-D21B-ABECFAE4B381}"/>
              </a:ext>
            </a:extLst>
          </p:cNvPr>
          <p:cNvSpPr txBox="1"/>
          <p:nvPr/>
        </p:nvSpPr>
        <p:spPr>
          <a:xfrm>
            <a:off x="2719344" y="1873782"/>
            <a:ext cx="136823" cy="61555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1EB652BA-B0C2-22A1-050A-579646BD82CA}"/>
              </a:ext>
            </a:extLst>
          </p:cNvPr>
          <p:cNvSpPr txBox="1"/>
          <p:nvPr/>
        </p:nvSpPr>
        <p:spPr>
          <a:xfrm>
            <a:off x="2822840" y="1873782"/>
            <a:ext cx="136823" cy="61555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C2B93047-962D-AD70-5865-2C0CC9531263}"/>
              </a:ext>
            </a:extLst>
          </p:cNvPr>
          <p:cNvSpPr txBox="1"/>
          <p:nvPr/>
        </p:nvSpPr>
        <p:spPr>
          <a:xfrm>
            <a:off x="2932708" y="1873782"/>
            <a:ext cx="136823" cy="61555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09073730-CB64-3FA6-37F4-4F9116F43C7D}"/>
              </a:ext>
            </a:extLst>
          </p:cNvPr>
          <p:cNvSpPr txBox="1"/>
          <p:nvPr/>
        </p:nvSpPr>
        <p:spPr>
          <a:xfrm>
            <a:off x="3067230" y="1873782"/>
            <a:ext cx="136823" cy="61555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pPr algn="ctr"/>
            <a:r>
              <a:rPr lang="en-US" altLang="ja-JP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</a:t>
            </a:r>
            <a:endParaRPr lang="ja-JP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5572369C-F053-18F0-AC62-28A52EF69E0E}"/>
              </a:ext>
            </a:extLst>
          </p:cNvPr>
          <p:cNvSpPr txBox="1"/>
          <p:nvPr/>
        </p:nvSpPr>
        <p:spPr>
          <a:xfrm>
            <a:off x="-71517" y="150107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5BFEB4DD-9B36-7CC9-B749-677FBF3268B4}"/>
              </a:ext>
            </a:extLst>
          </p:cNvPr>
          <p:cNvSpPr txBox="1"/>
          <p:nvPr/>
        </p:nvSpPr>
        <p:spPr>
          <a:xfrm>
            <a:off x="3998121" y="462907"/>
            <a:ext cx="407904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9F690DC0-1F6F-E4E1-FBBB-882452031B98}"/>
              </a:ext>
            </a:extLst>
          </p:cNvPr>
          <p:cNvSpPr txBox="1"/>
          <p:nvPr/>
        </p:nvSpPr>
        <p:spPr>
          <a:xfrm>
            <a:off x="4000904" y="736513"/>
            <a:ext cx="407904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8D7A8347-AFDD-01B0-9782-6B8FC8DE7FC7}"/>
              </a:ext>
            </a:extLst>
          </p:cNvPr>
          <p:cNvSpPr txBox="1"/>
          <p:nvPr/>
        </p:nvSpPr>
        <p:spPr>
          <a:xfrm>
            <a:off x="4000904" y="1005357"/>
            <a:ext cx="407904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16A92269-3C6A-C311-728F-51B4C0B58ED0}"/>
              </a:ext>
            </a:extLst>
          </p:cNvPr>
          <p:cNvSpPr txBox="1"/>
          <p:nvPr/>
        </p:nvSpPr>
        <p:spPr>
          <a:xfrm>
            <a:off x="3998407" y="1272154"/>
            <a:ext cx="407904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84E478F0-56BB-FF6B-1474-F36B7FE6B843}"/>
              </a:ext>
            </a:extLst>
          </p:cNvPr>
          <p:cNvSpPr txBox="1"/>
          <p:nvPr/>
        </p:nvSpPr>
        <p:spPr>
          <a:xfrm>
            <a:off x="4001019" y="1554107"/>
            <a:ext cx="407904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096BD203-CB05-CF37-9BC4-4F6010B3F081}"/>
              </a:ext>
            </a:extLst>
          </p:cNvPr>
          <p:cNvSpPr txBox="1"/>
          <p:nvPr/>
        </p:nvSpPr>
        <p:spPr>
          <a:xfrm>
            <a:off x="3882388" y="150110"/>
            <a:ext cx="2535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C0762E50-A4D5-BB5C-E75D-DD14B74CA805}"/>
              </a:ext>
            </a:extLst>
          </p:cNvPr>
          <p:cNvSpPr txBox="1"/>
          <p:nvPr/>
        </p:nvSpPr>
        <p:spPr>
          <a:xfrm>
            <a:off x="5590700" y="1649681"/>
            <a:ext cx="407904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69874A50-C2E6-C3E3-CEB5-22D7C03FAF87}"/>
              </a:ext>
            </a:extLst>
          </p:cNvPr>
          <p:cNvSpPr txBox="1"/>
          <p:nvPr/>
        </p:nvSpPr>
        <p:spPr>
          <a:xfrm>
            <a:off x="5216671" y="1647255"/>
            <a:ext cx="407904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70441D8C-57BD-19D0-1B80-BE6278EB92E0}"/>
              </a:ext>
            </a:extLst>
          </p:cNvPr>
          <p:cNvSpPr txBox="1"/>
          <p:nvPr/>
        </p:nvSpPr>
        <p:spPr>
          <a:xfrm>
            <a:off x="4832538" y="1643512"/>
            <a:ext cx="407904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1ECC0C57-3151-FFB3-D22E-64CC592537E8}"/>
              </a:ext>
            </a:extLst>
          </p:cNvPr>
          <p:cNvSpPr txBox="1"/>
          <p:nvPr/>
        </p:nvSpPr>
        <p:spPr>
          <a:xfrm>
            <a:off x="4453457" y="1643299"/>
            <a:ext cx="407904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B0A5A51A-C75F-17FE-2949-A0309FA0AB19}"/>
              </a:ext>
            </a:extLst>
          </p:cNvPr>
          <p:cNvSpPr txBox="1"/>
          <p:nvPr/>
        </p:nvSpPr>
        <p:spPr>
          <a:xfrm rot="16200000">
            <a:off x="3151440" y="974684"/>
            <a:ext cx="18533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bserved 3-year recurrence-free survival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F6655B68-B709-B906-4539-0FAA41067C1C}"/>
              </a:ext>
            </a:extLst>
          </p:cNvPr>
          <p:cNvSpPr txBox="1"/>
          <p:nvPr/>
        </p:nvSpPr>
        <p:spPr>
          <a:xfrm>
            <a:off x="4311817" y="1777120"/>
            <a:ext cx="18565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 3-year recurrence-free survival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1">
            <a:extLst>
              <a:ext uri="{FF2B5EF4-FFF2-40B4-BE49-F238E27FC236}">
                <a16:creationId xmlns:a16="http://schemas.microsoft.com/office/drawing/2014/main" id="{2786464F-5576-2082-981C-E4BA3D894B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8" y="2045862"/>
            <a:ext cx="3926675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SUP: The International Society of Urological Pathology, SM: surgical margin</a:t>
            </a:r>
            <a:r>
              <a:rPr lang="en-US" altLang="ja-JP" sz="8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kumimoji="0" lang="en-US" altLang="ja-JP" sz="8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SA: prostate specific antigen. </a:t>
            </a:r>
            <a:endParaRPr kumimoji="0" lang="en-US" altLang="ja-JP" sz="800" b="0" i="0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8644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846</TotalTime>
  <Words>251</Words>
  <Application>Microsoft Office PowerPoint</Application>
  <PresentationFormat>ユーザー設定</PresentationFormat>
  <Paragraphs>164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箱崎 勇治</dc:creator>
  <cp:lastModifiedBy>勇治 箱崎</cp:lastModifiedBy>
  <cp:revision>121</cp:revision>
  <cp:lastPrinted>2024-02-05T05:57:24Z</cp:lastPrinted>
  <dcterms:created xsi:type="dcterms:W3CDTF">2023-04-05T09:48:44Z</dcterms:created>
  <dcterms:modified xsi:type="dcterms:W3CDTF">2025-05-19T15:42:36Z</dcterms:modified>
</cp:coreProperties>
</file>